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90" r:id="rId2"/>
    <p:sldId id="293" r:id="rId3"/>
    <p:sldId id="294" r:id="rId4"/>
    <p:sldId id="295" r:id="rId5"/>
    <p:sldId id="296" r:id="rId6"/>
    <p:sldId id="297" r:id="rId7"/>
    <p:sldId id="299" r:id="rId8"/>
    <p:sldId id="298" r:id="rId9"/>
    <p:sldId id="300" r:id="rId10"/>
    <p:sldId id="301" r:id="rId11"/>
    <p:sldId id="302" r:id="rId12"/>
  </p:sldIdLst>
  <p:sldSz cx="46080363" cy="46080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00"/>
    <a:srgbClr val="00D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BF2A2A9-885E-47C2-BE5A-899992C17922}" v="28" dt="2024-08-02T02:01:22.0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3" autoAdjust="0"/>
    <p:restoredTop sz="96509" autoAdjust="0"/>
  </p:normalViewPr>
  <p:slideViewPr>
    <p:cSldViewPr snapToGrid="0">
      <p:cViewPr varScale="1">
        <p:scale>
          <a:sx n="16" d="100"/>
          <a:sy n="16" d="100"/>
        </p:scale>
        <p:origin x="2508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ohua xie" userId="28ac0b58a72c0b90" providerId="LiveId" clId="{6BF2A2A9-885E-47C2-BE5A-899992C17922}"/>
    <pc:docChg chg="custSel modSld">
      <pc:chgData name="shaohua xie" userId="28ac0b58a72c0b90" providerId="LiveId" clId="{6BF2A2A9-885E-47C2-BE5A-899992C17922}" dt="2024-08-02T02:01:23.259" v="163" actId="20577"/>
      <pc:docMkLst>
        <pc:docMk/>
      </pc:docMkLst>
      <pc:sldChg chg="addSp modSp mod">
        <pc:chgData name="shaohua xie" userId="28ac0b58a72c0b90" providerId="LiveId" clId="{6BF2A2A9-885E-47C2-BE5A-899992C17922}" dt="2024-08-02T02:01:23.259" v="163" actId="20577"/>
        <pc:sldMkLst>
          <pc:docMk/>
          <pc:sldMk cId="548649684" sldId="301"/>
        </pc:sldMkLst>
        <pc:spChg chg="add mod">
          <ac:chgData name="shaohua xie" userId="28ac0b58a72c0b90" providerId="LiveId" clId="{6BF2A2A9-885E-47C2-BE5A-899992C17922}" dt="2024-08-02T01:59:50.258" v="134" actId="1076"/>
          <ac:spMkLst>
            <pc:docMk/>
            <pc:sldMk cId="548649684" sldId="301"/>
            <ac:spMk id="23" creationId="{58D33ED8-4C81-F846-5B1B-AE25AA210446}"/>
          </ac:spMkLst>
        </pc:spChg>
        <pc:spChg chg="add mod">
          <ac:chgData name="shaohua xie" userId="28ac0b58a72c0b90" providerId="LiveId" clId="{6BF2A2A9-885E-47C2-BE5A-899992C17922}" dt="2024-08-02T01:59:55.740" v="136" actId="20577"/>
          <ac:spMkLst>
            <pc:docMk/>
            <pc:sldMk cId="548649684" sldId="301"/>
            <ac:spMk id="24" creationId="{03AFD9F0-6C68-529A-777C-C9086EFE80BF}"/>
          </ac:spMkLst>
        </pc:spChg>
        <pc:spChg chg="add mod">
          <ac:chgData name="shaohua xie" userId="28ac0b58a72c0b90" providerId="LiveId" clId="{6BF2A2A9-885E-47C2-BE5A-899992C17922}" dt="2024-08-02T02:00:04.189" v="138" actId="20577"/>
          <ac:spMkLst>
            <pc:docMk/>
            <pc:sldMk cId="548649684" sldId="301"/>
            <ac:spMk id="25" creationId="{ED1820AF-7617-A78B-80BB-9F5554FEAB26}"/>
          </ac:spMkLst>
        </pc:spChg>
        <pc:spChg chg="add mod">
          <ac:chgData name="shaohua xie" userId="28ac0b58a72c0b90" providerId="LiveId" clId="{6BF2A2A9-885E-47C2-BE5A-899992C17922}" dt="2024-08-02T02:00:18.922" v="143" actId="1035"/>
          <ac:spMkLst>
            <pc:docMk/>
            <pc:sldMk cId="548649684" sldId="301"/>
            <ac:spMk id="26" creationId="{6B0A65DB-4D7D-A5CF-FD3F-24E8065965C2}"/>
          </ac:spMkLst>
        </pc:spChg>
        <pc:spChg chg="add mod">
          <ac:chgData name="shaohua xie" userId="28ac0b58a72c0b90" providerId="LiveId" clId="{6BF2A2A9-885E-47C2-BE5A-899992C17922}" dt="2024-08-02T02:00:30.508" v="145" actId="20577"/>
          <ac:spMkLst>
            <pc:docMk/>
            <pc:sldMk cId="548649684" sldId="301"/>
            <ac:spMk id="27" creationId="{00620FCF-1C8A-585D-805E-D40E08130F85}"/>
          </ac:spMkLst>
        </pc:spChg>
        <pc:spChg chg="add mod">
          <ac:chgData name="shaohua xie" userId="28ac0b58a72c0b90" providerId="LiveId" clId="{6BF2A2A9-885E-47C2-BE5A-899992C17922}" dt="2024-08-02T02:00:39.868" v="147" actId="20577"/>
          <ac:spMkLst>
            <pc:docMk/>
            <pc:sldMk cId="548649684" sldId="301"/>
            <ac:spMk id="28" creationId="{E283094C-B719-74A3-952A-29DD3B9185D5}"/>
          </ac:spMkLst>
        </pc:spChg>
        <pc:spChg chg="add mod">
          <ac:chgData name="shaohua xie" userId="28ac0b58a72c0b90" providerId="LiveId" clId="{6BF2A2A9-885E-47C2-BE5A-899992C17922}" dt="2024-08-02T02:00:52.186" v="154" actId="1036"/>
          <ac:spMkLst>
            <pc:docMk/>
            <pc:sldMk cId="548649684" sldId="301"/>
            <ac:spMk id="29" creationId="{9544EB03-A3D2-4AB7-9E28-2E204F1EF81D}"/>
          </ac:spMkLst>
        </pc:spChg>
        <pc:spChg chg="add mod">
          <ac:chgData name="shaohua xie" userId="28ac0b58a72c0b90" providerId="LiveId" clId="{6BF2A2A9-885E-47C2-BE5A-899992C17922}" dt="2024-08-02T02:01:03.819" v="156" actId="20577"/>
          <ac:spMkLst>
            <pc:docMk/>
            <pc:sldMk cId="548649684" sldId="301"/>
            <ac:spMk id="30" creationId="{D9229752-9508-0498-C661-9F0A514D4ABE}"/>
          </ac:spMkLst>
        </pc:spChg>
        <pc:spChg chg="add mod">
          <ac:chgData name="shaohua xie" userId="28ac0b58a72c0b90" providerId="LiveId" clId="{6BF2A2A9-885E-47C2-BE5A-899992C17922}" dt="2024-08-02T02:01:16.668" v="161" actId="20577"/>
          <ac:spMkLst>
            <pc:docMk/>
            <pc:sldMk cId="548649684" sldId="301"/>
            <ac:spMk id="31" creationId="{F96345F9-2838-CA26-ED20-F9C22B9BF6AC}"/>
          </ac:spMkLst>
        </pc:spChg>
        <pc:spChg chg="add mod">
          <ac:chgData name="shaohua xie" userId="28ac0b58a72c0b90" providerId="LiveId" clId="{6BF2A2A9-885E-47C2-BE5A-899992C17922}" dt="2024-08-02T02:01:23.259" v="163" actId="20577"/>
          <ac:spMkLst>
            <pc:docMk/>
            <pc:sldMk cId="548649684" sldId="301"/>
            <ac:spMk id="32" creationId="{444528BF-35AA-642B-E5C2-D11D1625C623}"/>
          </ac:spMkLst>
        </pc:spChg>
        <pc:picChg chg="add mod">
          <ac:chgData name="shaohua xie" userId="28ac0b58a72c0b90" providerId="LiveId" clId="{6BF2A2A9-885E-47C2-BE5A-899992C17922}" dt="2024-08-02T01:53:16.209" v="4" actId="1076"/>
          <ac:picMkLst>
            <pc:docMk/>
            <pc:sldMk cId="548649684" sldId="301"/>
            <ac:picMk id="3" creationId="{CFA6ABEE-A690-66D5-6B4C-089915397380}"/>
          </ac:picMkLst>
        </pc:picChg>
        <pc:picChg chg="add mod">
          <ac:chgData name="shaohua xie" userId="28ac0b58a72c0b90" providerId="LiveId" clId="{6BF2A2A9-885E-47C2-BE5A-899992C17922}" dt="2024-08-02T01:58:35.980" v="113" actId="1076"/>
          <ac:picMkLst>
            <pc:docMk/>
            <pc:sldMk cId="548649684" sldId="301"/>
            <ac:picMk id="5" creationId="{AFA7FCC2-CC3F-AA2A-20DD-966DA25DA95E}"/>
          </ac:picMkLst>
        </pc:picChg>
        <pc:picChg chg="add mod">
          <ac:chgData name="shaohua xie" userId="28ac0b58a72c0b90" providerId="LiveId" clId="{6BF2A2A9-885E-47C2-BE5A-899992C17922}" dt="2024-08-02T01:58:39.540" v="114" actId="1076"/>
          <ac:picMkLst>
            <pc:docMk/>
            <pc:sldMk cId="548649684" sldId="301"/>
            <ac:picMk id="8" creationId="{6C498279-CEE2-1C4B-4A90-947385F16A35}"/>
          </ac:picMkLst>
        </pc:picChg>
        <pc:picChg chg="add mod">
          <ac:chgData name="shaohua xie" userId="28ac0b58a72c0b90" providerId="LiveId" clId="{6BF2A2A9-885E-47C2-BE5A-899992C17922}" dt="2024-08-02T01:58:42.763" v="115" actId="1076"/>
          <ac:picMkLst>
            <pc:docMk/>
            <pc:sldMk cId="548649684" sldId="301"/>
            <ac:picMk id="10" creationId="{BEF37B85-8B9B-5043-F213-455A916F7683}"/>
          </ac:picMkLst>
        </pc:picChg>
        <pc:picChg chg="add mod">
          <ac:chgData name="shaohua xie" userId="28ac0b58a72c0b90" providerId="LiveId" clId="{6BF2A2A9-885E-47C2-BE5A-899992C17922}" dt="2024-08-02T01:58:54.979" v="119" actId="1076"/>
          <ac:picMkLst>
            <pc:docMk/>
            <pc:sldMk cId="548649684" sldId="301"/>
            <ac:picMk id="12" creationId="{3781FA43-4DB3-337E-D910-CD69D03A8A26}"/>
          </ac:picMkLst>
        </pc:picChg>
        <pc:picChg chg="add mod">
          <ac:chgData name="shaohua xie" userId="28ac0b58a72c0b90" providerId="LiveId" clId="{6BF2A2A9-885E-47C2-BE5A-899992C17922}" dt="2024-08-02T01:58:49.875" v="118" actId="1076"/>
          <ac:picMkLst>
            <pc:docMk/>
            <pc:sldMk cId="548649684" sldId="301"/>
            <ac:picMk id="14" creationId="{5BA5EC18-9808-967E-A2BB-CE66D57F515E}"/>
          </ac:picMkLst>
        </pc:picChg>
        <pc:picChg chg="add mod">
          <ac:chgData name="shaohua xie" userId="28ac0b58a72c0b90" providerId="LiveId" clId="{6BF2A2A9-885E-47C2-BE5A-899992C17922}" dt="2024-08-02T01:58:59.834" v="120" actId="1076"/>
          <ac:picMkLst>
            <pc:docMk/>
            <pc:sldMk cId="548649684" sldId="301"/>
            <ac:picMk id="16" creationId="{B172BFB7-5FBD-C944-7BC2-CACD5D4227F1}"/>
          </ac:picMkLst>
        </pc:picChg>
        <pc:picChg chg="add mod">
          <ac:chgData name="shaohua xie" userId="28ac0b58a72c0b90" providerId="LiveId" clId="{6BF2A2A9-885E-47C2-BE5A-899992C17922}" dt="2024-08-02T01:59:06.283" v="121" actId="1076"/>
          <ac:picMkLst>
            <pc:docMk/>
            <pc:sldMk cId="548649684" sldId="301"/>
            <ac:picMk id="18" creationId="{FF528153-1B85-F30D-9475-730486F4A933}"/>
          </ac:picMkLst>
        </pc:picChg>
        <pc:picChg chg="add mod">
          <ac:chgData name="shaohua xie" userId="28ac0b58a72c0b90" providerId="LiveId" clId="{6BF2A2A9-885E-47C2-BE5A-899992C17922}" dt="2024-08-02T01:59:17.803" v="125" actId="1038"/>
          <ac:picMkLst>
            <pc:docMk/>
            <pc:sldMk cId="548649684" sldId="301"/>
            <ac:picMk id="20" creationId="{D35F7AF4-7B5B-8DCD-7E80-559CA4061C2E}"/>
          </ac:picMkLst>
        </pc:picChg>
        <pc:picChg chg="add mod">
          <ac:chgData name="shaohua xie" userId="28ac0b58a72c0b90" providerId="LiveId" clId="{6BF2A2A9-885E-47C2-BE5A-899992C17922}" dt="2024-08-02T01:59:14.380" v="123" actId="1076"/>
          <ac:picMkLst>
            <pc:docMk/>
            <pc:sldMk cId="548649684" sldId="301"/>
            <ac:picMk id="22" creationId="{D10225EB-0E8C-B604-3EAB-C12D16E7B41A}"/>
          </ac:picMkLst>
        </pc:picChg>
      </pc:sldChg>
      <pc:sldChg chg="addSp modSp mod">
        <pc:chgData name="shaohua xie" userId="28ac0b58a72c0b90" providerId="LiveId" clId="{6BF2A2A9-885E-47C2-BE5A-899992C17922}" dt="2024-08-02T01:58:13.367" v="110" actId="164"/>
        <pc:sldMkLst>
          <pc:docMk/>
          <pc:sldMk cId="184980166" sldId="302"/>
        </pc:sldMkLst>
        <pc:spChg chg="add mod">
          <ac:chgData name="shaohua xie" userId="28ac0b58a72c0b90" providerId="LiveId" clId="{6BF2A2A9-885E-47C2-BE5A-899992C17922}" dt="2024-08-02T01:56:51.099" v="89" actId="1076"/>
          <ac:spMkLst>
            <pc:docMk/>
            <pc:sldMk cId="184980166" sldId="302"/>
            <ac:spMk id="4" creationId="{BBBC50ED-081B-96F4-57C4-6866879D2545}"/>
          </ac:spMkLst>
        </pc:spChg>
        <pc:spChg chg="add mod">
          <ac:chgData name="shaohua xie" userId="28ac0b58a72c0b90" providerId="LiveId" clId="{6BF2A2A9-885E-47C2-BE5A-899992C17922}" dt="2024-08-02T01:58:13.367" v="110" actId="164"/>
          <ac:spMkLst>
            <pc:docMk/>
            <pc:sldMk cId="184980166" sldId="302"/>
            <ac:spMk id="5" creationId="{A4A37429-6EE5-B0F1-B879-040646A45083}"/>
          </ac:spMkLst>
        </pc:spChg>
        <pc:spChg chg="add mod">
          <ac:chgData name="shaohua xie" userId="28ac0b58a72c0b90" providerId="LiveId" clId="{6BF2A2A9-885E-47C2-BE5A-899992C17922}" dt="2024-08-02T01:57:30.120" v="98" actId="571"/>
          <ac:spMkLst>
            <pc:docMk/>
            <pc:sldMk cId="184980166" sldId="302"/>
            <ac:spMk id="8" creationId="{F553DBA0-4AD0-453F-4DDF-F76B1564DF1C}"/>
          </ac:spMkLst>
        </pc:spChg>
        <pc:spChg chg="add mod">
          <ac:chgData name="shaohua xie" userId="28ac0b58a72c0b90" providerId="LiveId" clId="{6BF2A2A9-885E-47C2-BE5A-899992C17922}" dt="2024-08-02T01:58:13.367" v="110" actId="164"/>
          <ac:spMkLst>
            <pc:docMk/>
            <pc:sldMk cId="184980166" sldId="302"/>
            <ac:spMk id="9" creationId="{06EEC770-9353-509C-5B43-A67357F43D64}"/>
          </ac:spMkLst>
        </pc:spChg>
        <pc:spChg chg="add mod">
          <ac:chgData name="shaohua xie" userId="28ac0b58a72c0b90" providerId="LiveId" clId="{6BF2A2A9-885E-47C2-BE5A-899992C17922}" dt="2024-08-02T01:58:13.367" v="110" actId="164"/>
          <ac:spMkLst>
            <pc:docMk/>
            <pc:sldMk cId="184980166" sldId="302"/>
            <ac:spMk id="10" creationId="{93244E07-F2C3-E186-E23C-09E8421991B0}"/>
          </ac:spMkLst>
        </pc:spChg>
        <pc:grpChg chg="add mod">
          <ac:chgData name="shaohua xie" userId="28ac0b58a72c0b90" providerId="LiveId" clId="{6BF2A2A9-885E-47C2-BE5A-899992C17922}" dt="2024-08-02T01:58:13.367" v="110" actId="164"/>
          <ac:grpSpMkLst>
            <pc:docMk/>
            <pc:sldMk cId="184980166" sldId="302"/>
            <ac:grpSpMk id="11" creationId="{EF5915AC-4973-CA3F-55AC-0C125A172973}"/>
          </ac:grpSpMkLst>
        </pc:grpChg>
        <pc:picChg chg="add mod">
          <ac:chgData name="shaohua xie" userId="28ac0b58a72c0b90" providerId="LiveId" clId="{6BF2A2A9-885E-47C2-BE5A-899992C17922}" dt="2024-08-02T01:58:13.367" v="110" actId="164"/>
          <ac:picMkLst>
            <pc:docMk/>
            <pc:sldMk cId="184980166" sldId="302"/>
            <ac:picMk id="3" creationId="{2D37E39F-E8F6-1066-1835-15AD95C43210}"/>
          </ac:picMkLst>
        </pc:picChg>
        <pc:picChg chg="add mod">
          <ac:chgData name="shaohua xie" userId="28ac0b58a72c0b90" providerId="LiveId" clId="{6BF2A2A9-885E-47C2-BE5A-899992C17922}" dt="2024-08-02T01:57:30.120" v="98" actId="571"/>
          <ac:picMkLst>
            <pc:docMk/>
            <pc:sldMk cId="184980166" sldId="302"/>
            <ac:picMk id="7" creationId="{29304786-FAC0-8F4B-8CFE-52AA1F50811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56027" y="7541396"/>
            <a:ext cx="39168309" cy="16042793"/>
          </a:xfrm>
        </p:spPr>
        <p:txBody>
          <a:bodyPr anchor="b"/>
          <a:lstStyle>
            <a:lvl1pPr algn="ctr">
              <a:defRPr sz="30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60046" y="24202860"/>
            <a:ext cx="34560272" cy="11125418"/>
          </a:xfrm>
        </p:spPr>
        <p:txBody>
          <a:bodyPr/>
          <a:lstStyle>
            <a:lvl1pPr marL="0" indent="0" algn="ctr">
              <a:buNone/>
              <a:defRPr sz="12095"/>
            </a:lvl1pPr>
            <a:lvl2pPr marL="2304014" indent="0" algn="ctr">
              <a:buNone/>
              <a:defRPr sz="10079"/>
            </a:lvl2pPr>
            <a:lvl3pPr marL="4608027" indent="0" algn="ctr">
              <a:buNone/>
              <a:defRPr sz="9071"/>
            </a:lvl3pPr>
            <a:lvl4pPr marL="6912041" indent="0" algn="ctr">
              <a:buNone/>
              <a:defRPr sz="8063"/>
            </a:lvl4pPr>
            <a:lvl5pPr marL="9216055" indent="0" algn="ctr">
              <a:buNone/>
              <a:defRPr sz="8063"/>
            </a:lvl5pPr>
            <a:lvl6pPr marL="11520068" indent="0" algn="ctr">
              <a:buNone/>
              <a:defRPr sz="8063"/>
            </a:lvl6pPr>
            <a:lvl7pPr marL="13824082" indent="0" algn="ctr">
              <a:buNone/>
              <a:defRPr sz="8063"/>
            </a:lvl7pPr>
            <a:lvl8pPr marL="16128096" indent="0" algn="ctr">
              <a:buNone/>
              <a:defRPr sz="8063"/>
            </a:lvl8pPr>
            <a:lvl9pPr marL="18432109" indent="0" algn="ctr">
              <a:buNone/>
              <a:defRPr sz="806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957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764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976262" y="2453352"/>
            <a:ext cx="9936078" cy="3905097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68028" y="2453352"/>
            <a:ext cx="29232230" cy="3905097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649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647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4027" y="11488104"/>
            <a:ext cx="39744313" cy="19168148"/>
          </a:xfrm>
        </p:spPr>
        <p:txBody>
          <a:bodyPr anchor="b"/>
          <a:lstStyle>
            <a:lvl1pPr>
              <a:defRPr sz="30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4027" y="30837590"/>
            <a:ext cx="39744313" cy="10080076"/>
          </a:xfrm>
        </p:spPr>
        <p:txBody>
          <a:bodyPr/>
          <a:lstStyle>
            <a:lvl1pPr marL="0" indent="0">
              <a:buNone/>
              <a:defRPr sz="12095">
                <a:solidFill>
                  <a:schemeClr val="tx1"/>
                </a:solidFill>
              </a:defRPr>
            </a:lvl1pPr>
            <a:lvl2pPr marL="2304014" indent="0">
              <a:buNone/>
              <a:defRPr sz="10079">
                <a:solidFill>
                  <a:schemeClr val="tx1">
                    <a:tint val="75000"/>
                  </a:schemeClr>
                </a:solidFill>
              </a:defRPr>
            </a:lvl2pPr>
            <a:lvl3pPr marL="4608027" indent="0">
              <a:buNone/>
              <a:defRPr sz="9071">
                <a:solidFill>
                  <a:schemeClr val="tx1">
                    <a:tint val="75000"/>
                  </a:schemeClr>
                </a:solidFill>
              </a:defRPr>
            </a:lvl3pPr>
            <a:lvl4pPr marL="6912041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4pPr>
            <a:lvl5pPr marL="9216055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5pPr>
            <a:lvl6pPr marL="11520068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6pPr>
            <a:lvl7pPr marL="13824082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7pPr>
            <a:lvl8pPr marL="16128096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8pPr>
            <a:lvl9pPr marL="18432109" indent="0">
              <a:buNone/>
              <a:defRPr sz="806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708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68025" y="12266763"/>
            <a:ext cx="19584154" cy="2923756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328184" y="12266763"/>
            <a:ext cx="19584154" cy="2923756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853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4027" y="2453363"/>
            <a:ext cx="39744313" cy="890674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74032" y="11296092"/>
            <a:ext cx="19494150" cy="5536040"/>
          </a:xfrm>
        </p:spPr>
        <p:txBody>
          <a:bodyPr anchor="b"/>
          <a:lstStyle>
            <a:lvl1pPr marL="0" indent="0">
              <a:buNone/>
              <a:defRPr sz="12095" b="1"/>
            </a:lvl1pPr>
            <a:lvl2pPr marL="2304014" indent="0">
              <a:buNone/>
              <a:defRPr sz="10079" b="1"/>
            </a:lvl2pPr>
            <a:lvl3pPr marL="4608027" indent="0">
              <a:buNone/>
              <a:defRPr sz="9071" b="1"/>
            </a:lvl3pPr>
            <a:lvl4pPr marL="6912041" indent="0">
              <a:buNone/>
              <a:defRPr sz="8063" b="1"/>
            </a:lvl4pPr>
            <a:lvl5pPr marL="9216055" indent="0">
              <a:buNone/>
              <a:defRPr sz="8063" b="1"/>
            </a:lvl5pPr>
            <a:lvl6pPr marL="11520068" indent="0">
              <a:buNone/>
              <a:defRPr sz="8063" b="1"/>
            </a:lvl6pPr>
            <a:lvl7pPr marL="13824082" indent="0">
              <a:buNone/>
              <a:defRPr sz="8063" b="1"/>
            </a:lvl7pPr>
            <a:lvl8pPr marL="16128096" indent="0">
              <a:buNone/>
              <a:defRPr sz="8063" b="1"/>
            </a:lvl8pPr>
            <a:lvl9pPr marL="18432109" indent="0">
              <a:buNone/>
              <a:defRPr sz="806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4032" y="16832132"/>
            <a:ext cx="19494150" cy="2475753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328186" y="11296092"/>
            <a:ext cx="19590156" cy="5536040"/>
          </a:xfrm>
        </p:spPr>
        <p:txBody>
          <a:bodyPr anchor="b"/>
          <a:lstStyle>
            <a:lvl1pPr marL="0" indent="0">
              <a:buNone/>
              <a:defRPr sz="12095" b="1"/>
            </a:lvl1pPr>
            <a:lvl2pPr marL="2304014" indent="0">
              <a:buNone/>
              <a:defRPr sz="10079" b="1"/>
            </a:lvl2pPr>
            <a:lvl3pPr marL="4608027" indent="0">
              <a:buNone/>
              <a:defRPr sz="9071" b="1"/>
            </a:lvl3pPr>
            <a:lvl4pPr marL="6912041" indent="0">
              <a:buNone/>
              <a:defRPr sz="8063" b="1"/>
            </a:lvl4pPr>
            <a:lvl5pPr marL="9216055" indent="0">
              <a:buNone/>
              <a:defRPr sz="8063" b="1"/>
            </a:lvl5pPr>
            <a:lvl6pPr marL="11520068" indent="0">
              <a:buNone/>
              <a:defRPr sz="8063" b="1"/>
            </a:lvl6pPr>
            <a:lvl7pPr marL="13824082" indent="0">
              <a:buNone/>
              <a:defRPr sz="8063" b="1"/>
            </a:lvl7pPr>
            <a:lvl8pPr marL="16128096" indent="0">
              <a:buNone/>
              <a:defRPr sz="8063" b="1"/>
            </a:lvl8pPr>
            <a:lvl9pPr marL="18432109" indent="0">
              <a:buNone/>
              <a:defRPr sz="806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328186" y="16832132"/>
            <a:ext cx="19590156" cy="2475753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811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39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198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4027" y="3072024"/>
            <a:ext cx="14862116" cy="10752085"/>
          </a:xfrm>
        </p:spPr>
        <p:txBody>
          <a:bodyPr anchor="b"/>
          <a:lstStyle>
            <a:lvl1pPr>
              <a:defRPr sz="1612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590156" y="6634729"/>
            <a:ext cx="23328184" cy="32746925"/>
          </a:xfrm>
        </p:spPr>
        <p:txBody>
          <a:bodyPr/>
          <a:lstStyle>
            <a:lvl1pPr>
              <a:defRPr sz="16126"/>
            </a:lvl1pPr>
            <a:lvl2pPr>
              <a:defRPr sz="14110"/>
            </a:lvl2pPr>
            <a:lvl3pPr>
              <a:defRPr sz="12095"/>
            </a:lvl3pPr>
            <a:lvl4pPr>
              <a:defRPr sz="10079"/>
            </a:lvl4pPr>
            <a:lvl5pPr>
              <a:defRPr sz="10079"/>
            </a:lvl5pPr>
            <a:lvl6pPr>
              <a:defRPr sz="10079"/>
            </a:lvl6pPr>
            <a:lvl7pPr>
              <a:defRPr sz="10079"/>
            </a:lvl7pPr>
            <a:lvl8pPr>
              <a:defRPr sz="10079"/>
            </a:lvl8pPr>
            <a:lvl9pPr>
              <a:defRPr sz="1007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74027" y="13824109"/>
            <a:ext cx="14862116" cy="25610872"/>
          </a:xfrm>
        </p:spPr>
        <p:txBody>
          <a:bodyPr/>
          <a:lstStyle>
            <a:lvl1pPr marL="0" indent="0">
              <a:buNone/>
              <a:defRPr sz="8063"/>
            </a:lvl1pPr>
            <a:lvl2pPr marL="2304014" indent="0">
              <a:buNone/>
              <a:defRPr sz="7055"/>
            </a:lvl2pPr>
            <a:lvl3pPr marL="4608027" indent="0">
              <a:buNone/>
              <a:defRPr sz="6047"/>
            </a:lvl3pPr>
            <a:lvl4pPr marL="6912041" indent="0">
              <a:buNone/>
              <a:defRPr sz="5039"/>
            </a:lvl4pPr>
            <a:lvl5pPr marL="9216055" indent="0">
              <a:buNone/>
              <a:defRPr sz="5039"/>
            </a:lvl5pPr>
            <a:lvl6pPr marL="11520068" indent="0">
              <a:buNone/>
              <a:defRPr sz="5039"/>
            </a:lvl6pPr>
            <a:lvl7pPr marL="13824082" indent="0">
              <a:buNone/>
              <a:defRPr sz="5039"/>
            </a:lvl7pPr>
            <a:lvl8pPr marL="16128096" indent="0">
              <a:buNone/>
              <a:defRPr sz="5039"/>
            </a:lvl8pPr>
            <a:lvl9pPr marL="18432109" indent="0">
              <a:buNone/>
              <a:defRPr sz="503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312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4027" y="3072024"/>
            <a:ext cx="14862116" cy="10752085"/>
          </a:xfrm>
        </p:spPr>
        <p:txBody>
          <a:bodyPr anchor="b"/>
          <a:lstStyle>
            <a:lvl1pPr>
              <a:defRPr sz="1612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590156" y="6634729"/>
            <a:ext cx="23328184" cy="32746925"/>
          </a:xfrm>
        </p:spPr>
        <p:txBody>
          <a:bodyPr anchor="t"/>
          <a:lstStyle>
            <a:lvl1pPr marL="0" indent="0">
              <a:buNone/>
              <a:defRPr sz="16126"/>
            </a:lvl1pPr>
            <a:lvl2pPr marL="2304014" indent="0">
              <a:buNone/>
              <a:defRPr sz="14110"/>
            </a:lvl2pPr>
            <a:lvl3pPr marL="4608027" indent="0">
              <a:buNone/>
              <a:defRPr sz="12095"/>
            </a:lvl3pPr>
            <a:lvl4pPr marL="6912041" indent="0">
              <a:buNone/>
              <a:defRPr sz="10079"/>
            </a:lvl4pPr>
            <a:lvl5pPr marL="9216055" indent="0">
              <a:buNone/>
              <a:defRPr sz="10079"/>
            </a:lvl5pPr>
            <a:lvl6pPr marL="11520068" indent="0">
              <a:buNone/>
              <a:defRPr sz="10079"/>
            </a:lvl6pPr>
            <a:lvl7pPr marL="13824082" indent="0">
              <a:buNone/>
              <a:defRPr sz="10079"/>
            </a:lvl7pPr>
            <a:lvl8pPr marL="16128096" indent="0">
              <a:buNone/>
              <a:defRPr sz="10079"/>
            </a:lvl8pPr>
            <a:lvl9pPr marL="18432109" indent="0">
              <a:buNone/>
              <a:defRPr sz="1007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74027" y="13824109"/>
            <a:ext cx="14862116" cy="25610872"/>
          </a:xfrm>
        </p:spPr>
        <p:txBody>
          <a:bodyPr/>
          <a:lstStyle>
            <a:lvl1pPr marL="0" indent="0">
              <a:buNone/>
              <a:defRPr sz="8063"/>
            </a:lvl1pPr>
            <a:lvl2pPr marL="2304014" indent="0">
              <a:buNone/>
              <a:defRPr sz="7055"/>
            </a:lvl2pPr>
            <a:lvl3pPr marL="4608027" indent="0">
              <a:buNone/>
              <a:defRPr sz="6047"/>
            </a:lvl3pPr>
            <a:lvl4pPr marL="6912041" indent="0">
              <a:buNone/>
              <a:defRPr sz="5039"/>
            </a:lvl4pPr>
            <a:lvl5pPr marL="9216055" indent="0">
              <a:buNone/>
              <a:defRPr sz="5039"/>
            </a:lvl5pPr>
            <a:lvl6pPr marL="11520068" indent="0">
              <a:buNone/>
              <a:defRPr sz="5039"/>
            </a:lvl6pPr>
            <a:lvl7pPr marL="13824082" indent="0">
              <a:buNone/>
              <a:defRPr sz="5039"/>
            </a:lvl7pPr>
            <a:lvl8pPr marL="16128096" indent="0">
              <a:buNone/>
              <a:defRPr sz="5039"/>
            </a:lvl8pPr>
            <a:lvl9pPr marL="18432109" indent="0">
              <a:buNone/>
              <a:defRPr sz="503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56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68025" y="2453363"/>
            <a:ext cx="39744313" cy="890674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68025" y="12266763"/>
            <a:ext cx="39744313" cy="292375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68025" y="42709680"/>
            <a:ext cx="10368082" cy="24533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4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6F262-D2C1-4CC7-85E9-1376C91747B6}" type="datetimeFigureOut">
              <a:rPr lang="en-US" smtClean="0"/>
              <a:t>8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264120" y="42709680"/>
            <a:ext cx="15552123" cy="24533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4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544256" y="42709680"/>
            <a:ext cx="10368082" cy="24533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4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DD649-D565-467F-AFB1-CAD62CD4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803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4608027" rtl="0" eaLnBrk="1" latinLnBrk="0" hangingPunct="1">
        <a:lnSpc>
          <a:spcPct val="90000"/>
        </a:lnSpc>
        <a:spcBef>
          <a:spcPct val="0"/>
        </a:spcBef>
        <a:buNone/>
        <a:defRPr sz="221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52007" indent="-1152007" algn="l" defTabSz="4608027" rtl="0" eaLnBrk="1" latinLnBrk="0" hangingPunct="1">
        <a:lnSpc>
          <a:spcPct val="90000"/>
        </a:lnSpc>
        <a:spcBef>
          <a:spcPts val="5039"/>
        </a:spcBef>
        <a:buFont typeface="Arial" panose="020B0604020202020204" pitchFamily="34" charset="0"/>
        <a:buChar char="•"/>
        <a:defRPr sz="14110" kern="1200">
          <a:solidFill>
            <a:schemeClr val="tx1"/>
          </a:solidFill>
          <a:latin typeface="+mn-lt"/>
          <a:ea typeface="+mn-ea"/>
          <a:cs typeface="+mn-cs"/>
        </a:defRPr>
      </a:lvl1pPr>
      <a:lvl2pPr marL="3456021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12095" kern="1200">
          <a:solidFill>
            <a:schemeClr val="tx1"/>
          </a:solidFill>
          <a:latin typeface="+mn-lt"/>
          <a:ea typeface="+mn-ea"/>
          <a:cs typeface="+mn-cs"/>
        </a:defRPr>
      </a:lvl2pPr>
      <a:lvl3pPr marL="5760034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10079" kern="1200">
          <a:solidFill>
            <a:schemeClr val="tx1"/>
          </a:solidFill>
          <a:latin typeface="+mn-lt"/>
          <a:ea typeface="+mn-ea"/>
          <a:cs typeface="+mn-cs"/>
        </a:defRPr>
      </a:lvl3pPr>
      <a:lvl4pPr marL="8064048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4pPr>
      <a:lvl5pPr marL="10368062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5pPr>
      <a:lvl6pPr marL="12672075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6pPr>
      <a:lvl7pPr marL="14976089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7pPr>
      <a:lvl8pPr marL="17280103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8pPr>
      <a:lvl9pPr marL="19584116" indent="-1152007" algn="l" defTabSz="4608027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90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1pPr>
      <a:lvl2pPr marL="2304014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2pPr>
      <a:lvl3pPr marL="4608027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3pPr>
      <a:lvl4pPr marL="6912041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4pPr>
      <a:lvl5pPr marL="9216055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5pPr>
      <a:lvl6pPr marL="11520068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6pPr>
      <a:lvl7pPr marL="13824082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7pPr>
      <a:lvl8pPr marL="16128096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8pPr>
      <a:lvl9pPr marL="18432109" algn="l" defTabSz="4608027" rtl="0" eaLnBrk="1" latinLnBrk="0" hangingPunct="1">
        <a:defRPr sz="90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png"/><Relationship Id="rId11" Type="http://schemas.openxmlformats.org/officeDocument/2006/relationships/image" Target="../media/image56.png"/><Relationship Id="rId5" Type="http://schemas.openxmlformats.org/officeDocument/2006/relationships/image" Target="../media/image50.png"/><Relationship Id="rId10" Type="http://schemas.openxmlformats.org/officeDocument/2006/relationships/image" Target="../media/image55.png"/><Relationship Id="rId4" Type="http://schemas.openxmlformats.org/officeDocument/2006/relationships/image" Target="../media/image49.png"/><Relationship Id="rId9" Type="http://schemas.openxmlformats.org/officeDocument/2006/relationships/image" Target="../media/image54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"/><Relationship Id="rId3" Type="http://schemas.openxmlformats.org/officeDocument/2006/relationships/image" Target="../media/image14.tif"/><Relationship Id="rId7" Type="http://schemas.openxmlformats.org/officeDocument/2006/relationships/image" Target="../media/image18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"/><Relationship Id="rId3" Type="http://schemas.openxmlformats.org/officeDocument/2006/relationships/image" Target="../media/image21.tif"/><Relationship Id="rId7" Type="http://schemas.openxmlformats.org/officeDocument/2006/relationships/image" Target="../media/image25.tif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tif"/><Relationship Id="rId5" Type="http://schemas.openxmlformats.org/officeDocument/2006/relationships/image" Target="../media/image23.tif"/><Relationship Id="rId4" Type="http://schemas.openxmlformats.org/officeDocument/2006/relationships/image" Target="../media/image2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7081196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11a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B3C9FE68-B1F6-6587-E5B0-56C7C56E91B9}"/>
              </a:ext>
            </a:extLst>
          </p:cNvPr>
          <p:cNvGrpSpPr>
            <a:grpSpLocks noChangeAspect="1"/>
          </p:cNvGrpSpPr>
          <p:nvPr/>
        </p:nvGrpSpPr>
        <p:grpSpPr>
          <a:xfrm>
            <a:off x="16501524" y="8499881"/>
            <a:ext cx="13529511" cy="13529511"/>
            <a:chOff x="2176876" y="1793130"/>
            <a:chExt cx="1600201" cy="1600201"/>
          </a:xfrm>
        </p:grpSpPr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BFC33A53-6313-7754-93B2-D087F09228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6877" y="1793130"/>
              <a:ext cx="1600200" cy="1600200"/>
            </a:xfrm>
            <a:prstGeom prst="rect">
              <a:avLst/>
            </a:prstGeom>
          </p:spPr>
        </p:pic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4EC137B3-F962-6E4B-22C0-8E195F532AEA}"/>
                </a:ext>
              </a:extLst>
            </p:cNvPr>
            <p:cNvGrpSpPr/>
            <p:nvPr/>
          </p:nvGrpSpPr>
          <p:grpSpPr>
            <a:xfrm>
              <a:off x="2176876" y="3128256"/>
              <a:ext cx="553357" cy="265075"/>
              <a:chOff x="2176876" y="3128256"/>
              <a:chExt cx="553357" cy="265075"/>
            </a:xfrm>
          </p:grpSpPr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E9B572E4-69EE-600B-5893-AC068D73AEEA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BCD0ABC6-8BC0-E1D0-1F52-8027E21697E7}"/>
                  </a:ext>
                </a:extLst>
              </p:cNvPr>
              <p:cNvCxnSpPr/>
              <p:nvPr/>
            </p:nvCxnSpPr>
            <p:spPr>
              <a:xfrm>
                <a:off x="2334682" y="3326969"/>
                <a:ext cx="237744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00A6ED55-5944-F83F-A857-DD4E5E837FE1}"/>
                  </a:ext>
                </a:extLst>
              </p:cNvPr>
              <p:cNvSpPr txBox="1"/>
              <p:nvPr/>
            </p:nvSpPr>
            <p:spPr>
              <a:xfrm>
                <a:off x="2234556" y="3128256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nm</a:t>
                </a:r>
              </a:p>
            </p:txBody>
          </p:sp>
        </p:grp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FB80DA6D-389D-2BCB-9229-5261ABB1525F}"/>
              </a:ext>
            </a:extLst>
          </p:cNvPr>
          <p:cNvGrpSpPr>
            <a:grpSpLocks noChangeAspect="1"/>
          </p:cNvGrpSpPr>
          <p:nvPr/>
        </p:nvGrpSpPr>
        <p:grpSpPr>
          <a:xfrm>
            <a:off x="16517512" y="22245144"/>
            <a:ext cx="13529503" cy="13529503"/>
            <a:chOff x="3835564" y="1793130"/>
            <a:chExt cx="1600200" cy="1600200"/>
          </a:xfrm>
        </p:grpSpPr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id="{E5D1A539-BD52-2F21-6E71-256CDBE785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35564" y="1793130"/>
              <a:ext cx="1600200" cy="1600200"/>
            </a:xfrm>
            <a:prstGeom prst="rect">
              <a:avLst/>
            </a:prstGeom>
          </p:spPr>
        </p:pic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1D92B3CA-1923-1437-0123-71A2D812AD6B}"/>
                </a:ext>
              </a:extLst>
            </p:cNvPr>
            <p:cNvGrpSpPr/>
            <p:nvPr/>
          </p:nvGrpSpPr>
          <p:grpSpPr>
            <a:xfrm>
              <a:off x="3835564" y="3129491"/>
              <a:ext cx="553357" cy="260664"/>
              <a:chOff x="2176876" y="3132667"/>
              <a:chExt cx="553357" cy="260664"/>
            </a:xfrm>
          </p:grpSpPr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655CEA83-10D3-5640-DD18-19AD5200CAFD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id="{84118201-A0A0-5682-45B0-C226F0E0F6E1}"/>
                  </a:ext>
                </a:extLst>
              </p:cNvPr>
              <p:cNvCxnSpPr/>
              <p:nvPr/>
            </p:nvCxnSpPr>
            <p:spPr>
              <a:xfrm>
                <a:off x="2341032" y="3326969"/>
                <a:ext cx="219456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217D5379-DA89-3520-AA08-EEE8B7C854A8}"/>
                  </a:ext>
                </a:extLst>
              </p:cNvPr>
              <p:cNvSpPr txBox="1"/>
              <p:nvPr/>
            </p:nvSpPr>
            <p:spPr>
              <a:xfrm>
                <a:off x="2241766" y="3138641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C8C5A0EB-42B2-E45E-6875-B614CBBE528E}"/>
              </a:ext>
            </a:extLst>
          </p:cNvPr>
          <p:cNvGrpSpPr>
            <a:grpSpLocks noChangeAspect="1"/>
          </p:cNvGrpSpPr>
          <p:nvPr/>
        </p:nvGrpSpPr>
        <p:grpSpPr>
          <a:xfrm>
            <a:off x="2708263" y="22211561"/>
            <a:ext cx="13529503" cy="13529503"/>
            <a:chOff x="3835564" y="148361"/>
            <a:chExt cx="1600200" cy="1600200"/>
          </a:xfrm>
        </p:grpSpPr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C649CD9C-A1C9-167A-3752-FAC5310DD9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35564" y="148361"/>
              <a:ext cx="1600200" cy="1600200"/>
            </a:xfrm>
            <a:prstGeom prst="rect">
              <a:avLst/>
            </a:prstGeom>
          </p:spPr>
        </p:pic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207AD2F4-36EC-8964-27C3-4391BF1D80A3}"/>
                </a:ext>
              </a:extLst>
            </p:cNvPr>
            <p:cNvGrpSpPr/>
            <p:nvPr/>
          </p:nvGrpSpPr>
          <p:grpSpPr>
            <a:xfrm>
              <a:off x="3835564" y="1487897"/>
              <a:ext cx="553357" cy="260664"/>
              <a:chOff x="2176876" y="3132667"/>
              <a:chExt cx="553357" cy="260664"/>
            </a:xfrm>
          </p:grpSpPr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id="{52676081-E3FE-9E28-CF4E-0FCD2DFA2814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1AF783B6-46E4-3300-3641-ED6AC147E357}"/>
                  </a:ext>
                </a:extLst>
              </p:cNvPr>
              <p:cNvCxnSpPr/>
              <p:nvPr/>
            </p:nvCxnSpPr>
            <p:spPr>
              <a:xfrm>
                <a:off x="2341032" y="3326969"/>
                <a:ext cx="219456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9FFBDFD1-97C3-6560-C931-ECE1582C8CBC}"/>
                  </a:ext>
                </a:extLst>
              </p:cNvPr>
              <p:cNvSpPr txBox="1"/>
              <p:nvPr/>
            </p:nvSpPr>
            <p:spPr>
              <a:xfrm>
                <a:off x="2241766" y="3138641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5F6522B4-0FA8-8BBC-F21D-317435200CA6}"/>
              </a:ext>
            </a:extLst>
          </p:cNvPr>
          <p:cNvGrpSpPr>
            <a:grpSpLocks noChangeAspect="1"/>
          </p:cNvGrpSpPr>
          <p:nvPr/>
        </p:nvGrpSpPr>
        <p:grpSpPr>
          <a:xfrm>
            <a:off x="30326760" y="8499881"/>
            <a:ext cx="13529503" cy="13529503"/>
            <a:chOff x="5494251" y="148361"/>
            <a:chExt cx="1600200" cy="1600200"/>
          </a:xfrm>
        </p:grpSpPr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99CC2FEA-BAD9-6239-2F4F-17BED3D2B96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4251" y="148361"/>
              <a:ext cx="1600200" cy="1600200"/>
            </a:xfrm>
            <a:prstGeom prst="rect">
              <a:avLst/>
            </a:prstGeom>
          </p:spPr>
        </p:pic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3DBF545D-1A5D-8F5D-5B2E-CD6187AF01C2}"/>
                </a:ext>
              </a:extLst>
            </p:cNvPr>
            <p:cNvGrpSpPr/>
            <p:nvPr/>
          </p:nvGrpSpPr>
          <p:grpSpPr>
            <a:xfrm>
              <a:off x="5494251" y="1486661"/>
              <a:ext cx="553357" cy="261900"/>
              <a:chOff x="2176876" y="3131431"/>
              <a:chExt cx="553357" cy="261900"/>
            </a:xfrm>
          </p:grpSpPr>
          <p:sp>
            <p:nvSpPr>
              <p:cNvPr id="125" name="Rectangle 124">
                <a:extLst>
                  <a:ext uri="{FF2B5EF4-FFF2-40B4-BE49-F238E27FC236}">
                    <a16:creationId xmlns:a16="http://schemas.microsoft.com/office/drawing/2014/main" id="{B5EE28C6-585C-D283-AB53-F2A3E0A943F2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26" name="Straight Connector 125">
                <a:extLst>
                  <a:ext uri="{FF2B5EF4-FFF2-40B4-BE49-F238E27FC236}">
                    <a16:creationId xmlns:a16="http://schemas.microsoft.com/office/drawing/2014/main" id="{28D2ACB2-FD5E-6867-9748-9086C29E4B41}"/>
                  </a:ext>
                </a:extLst>
              </p:cNvPr>
              <p:cNvCxnSpPr/>
              <p:nvPr/>
            </p:nvCxnSpPr>
            <p:spPr>
              <a:xfrm>
                <a:off x="2341032" y="3326969"/>
                <a:ext cx="219456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1334CEC4-6BCE-75E0-88DE-5D849D27DC94}"/>
                  </a:ext>
                </a:extLst>
              </p:cNvPr>
              <p:cNvSpPr txBox="1"/>
              <p:nvPr/>
            </p:nvSpPr>
            <p:spPr>
              <a:xfrm>
                <a:off x="2234556" y="3131431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641B4C52-0B78-CE93-5D08-88B864AAF0DC}"/>
              </a:ext>
            </a:extLst>
          </p:cNvPr>
          <p:cNvGrpSpPr>
            <a:grpSpLocks noChangeAspect="1"/>
          </p:cNvGrpSpPr>
          <p:nvPr/>
        </p:nvGrpSpPr>
        <p:grpSpPr>
          <a:xfrm>
            <a:off x="2708263" y="8499881"/>
            <a:ext cx="13529503" cy="13536579"/>
            <a:chOff x="2176877" y="148361"/>
            <a:chExt cx="1600200" cy="1601037"/>
          </a:xfrm>
        </p:grpSpPr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E8C01DA6-7687-5A4C-5D02-CD77E92E134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6877" y="148361"/>
              <a:ext cx="1600200" cy="1600200"/>
            </a:xfrm>
            <a:prstGeom prst="rect">
              <a:avLst/>
            </a:prstGeom>
          </p:spPr>
        </p:pic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5E02FF13-F638-3954-5E81-EB90597E2D37}"/>
                </a:ext>
              </a:extLst>
            </p:cNvPr>
            <p:cNvGrpSpPr/>
            <p:nvPr/>
          </p:nvGrpSpPr>
          <p:grpSpPr>
            <a:xfrm>
              <a:off x="2176877" y="1480089"/>
              <a:ext cx="553357" cy="269309"/>
              <a:chOff x="2176876" y="3124022"/>
              <a:chExt cx="553357" cy="269309"/>
            </a:xfrm>
          </p:grpSpPr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6103119B-B5EA-5E29-E2DE-9744847F7C4F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3A284B98-56BB-6B8E-26A8-D97433D4290C}"/>
                  </a:ext>
                </a:extLst>
              </p:cNvPr>
              <p:cNvCxnSpPr/>
              <p:nvPr/>
            </p:nvCxnSpPr>
            <p:spPr>
              <a:xfrm>
                <a:off x="2326214" y="3326969"/>
                <a:ext cx="256032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AB779E45-970D-CECA-1763-9F408458641D}"/>
                  </a:ext>
                </a:extLst>
              </p:cNvPr>
              <p:cNvSpPr txBox="1"/>
              <p:nvPr/>
            </p:nvSpPr>
            <p:spPr>
              <a:xfrm>
                <a:off x="2234556" y="3124022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nm</a:t>
                </a:r>
              </a:p>
            </p:txBody>
          </p:sp>
        </p:grpSp>
      </p:grpSp>
      <p:grpSp>
        <p:nvGrpSpPr>
          <p:cNvPr id="164" name="Group 163">
            <a:extLst>
              <a:ext uri="{FF2B5EF4-FFF2-40B4-BE49-F238E27FC236}">
                <a16:creationId xmlns:a16="http://schemas.microsoft.com/office/drawing/2014/main" id="{1DB7D60F-71B0-3722-E9C5-789749F7A248}"/>
              </a:ext>
            </a:extLst>
          </p:cNvPr>
          <p:cNvGrpSpPr>
            <a:grpSpLocks noChangeAspect="1"/>
          </p:cNvGrpSpPr>
          <p:nvPr/>
        </p:nvGrpSpPr>
        <p:grpSpPr>
          <a:xfrm>
            <a:off x="30326760" y="22245144"/>
            <a:ext cx="13529503" cy="13534068"/>
            <a:chOff x="5494251" y="1793130"/>
            <a:chExt cx="1600200" cy="1600740"/>
          </a:xfrm>
        </p:grpSpPr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BBCF4AA1-AFA0-D398-AE8D-5643AC5760A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4251" y="1793130"/>
              <a:ext cx="1600200" cy="1600200"/>
            </a:xfrm>
            <a:prstGeom prst="rect">
              <a:avLst/>
            </a:prstGeom>
          </p:spPr>
        </p:pic>
        <p:grpSp>
          <p:nvGrpSpPr>
            <p:cNvPr id="166" name="Group 165">
              <a:extLst>
                <a:ext uri="{FF2B5EF4-FFF2-40B4-BE49-F238E27FC236}">
                  <a16:creationId xmlns:a16="http://schemas.microsoft.com/office/drawing/2014/main" id="{32041EB1-07DC-5E17-31E7-5B493A6A0871}"/>
                </a:ext>
              </a:extLst>
            </p:cNvPr>
            <p:cNvGrpSpPr/>
            <p:nvPr/>
          </p:nvGrpSpPr>
          <p:grpSpPr>
            <a:xfrm>
              <a:off x="5495689" y="3131771"/>
              <a:ext cx="553357" cy="262099"/>
              <a:chOff x="2176876" y="3131232"/>
              <a:chExt cx="553357" cy="262099"/>
            </a:xfrm>
          </p:grpSpPr>
          <p:sp>
            <p:nvSpPr>
              <p:cNvPr id="167" name="Rectangle 166">
                <a:extLst>
                  <a:ext uri="{FF2B5EF4-FFF2-40B4-BE49-F238E27FC236}">
                    <a16:creationId xmlns:a16="http://schemas.microsoft.com/office/drawing/2014/main" id="{A917F81E-C93B-793D-3E82-46FBD81FE7FE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68" name="Straight Connector 167">
                <a:extLst>
                  <a:ext uri="{FF2B5EF4-FFF2-40B4-BE49-F238E27FC236}">
                    <a16:creationId xmlns:a16="http://schemas.microsoft.com/office/drawing/2014/main" id="{530D0E65-2B8E-2678-4607-0B31CB0C232E}"/>
                  </a:ext>
                </a:extLst>
              </p:cNvPr>
              <p:cNvCxnSpPr/>
              <p:nvPr/>
            </p:nvCxnSpPr>
            <p:spPr>
              <a:xfrm>
                <a:off x="2326214" y="3326969"/>
                <a:ext cx="256032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D2C8ECDF-8050-5968-CCA7-79D225D71807}"/>
                  </a:ext>
                </a:extLst>
              </p:cNvPr>
              <p:cNvSpPr txBox="1"/>
              <p:nvPr/>
            </p:nvSpPr>
            <p:spPr>
              <a:xfrm>
                <a:off x="2241766" y="3131232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279928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7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CFA6ABEE-A690-66D5-6B4C-0899153973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1672" y="11125548"/>
            <a:ext cx="9144000" cy="7852775"/>
          </a:xfrm>
          <a:prstGeom prst="rect">
            <a:avLst/>
          </a:prstGeom>
        </p:spPr>
      </p:pic>
      <p:pic>
        <p:nvPicPr>
          <p:cNvPr id="5" name="Picture 4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AFA7FCC2-CC3F-AA2A-20DD-966DA25DA9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6792" y="11064588"/>
            <a:ext cx="9144000" cy="7852775"/>
          </a:xfrm>
          <a:prstGeom prst="rect">
            <a:avLst/>
          </a:prstGeom>
        </p:spPr>
      </p:pic>
      <p:pic>
        <p:nvPicPr>
          <p:cNvPr id="8" name="Picture 7" descr="A group of spheres with red and blue spheres&#10;&#10;Description automatically generated">
            <a:extLst>
              <a:ext uri="{FF2B5EF4-FFF2-40B4-BE49-F238E27FC236}">
                <a16:creationId xmlns:a16="http://schemas.microsoft.com/office/drawing/2014/main" id="{6C498279-CEE2-1C4B-4A90-947385F16A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2872" y="11003628"/>
            <a:ext cx="9144000" cy="7852775"/>
          </a:xfrm>
          <a:prstGeom prst="rect">
            <a:avLst/>
          </a:prstGeom>
        </p:spPr>
      </p:pic>
      <p:pic>
        <p:nvPicPr>
          <p:cNvPr id="10" name="Picture 9" descr="A group of spheres with red and blue spheres&#10;&#10;Description automatically generated">
            <a:extLst>
              <a:ext uri="{FF2B5EF4-FFF2-40B4-BE49-F238E27FC236}">
                <a16:creationId xmlns:a16="http://schemas.microsoft.com/office/drawing/2014/main" id="{BEF37B85-8B9B-5043-F213-455A916F768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7992" y="11064588"/>
            <a:ext cx="9144000" cy="7852775"/>
          </a:xfrm>
          <a:prstGeom prst="rect">
            <a:avLst/>
          </a:prstGeom>
        </p:spPr>
      </p:pic>
      <p:pic>
        <p:nvPicPr>
          <p:cNvPr id="12" name="Picture 11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3781FA43-4DB3-337E-D910-CD69D03A8A2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3592" y="21488748"/>
            <a:ext cx="9144000" cy="7852775"/>
          </a:xfrm>
          <a:prstGeom prst="rect">
            <a:avLst/>
          </a:prstGeom>
        </p:spPr>
      </p:pic>
      <p:pic>
        <p:nvPicPr>
          <p:cNvPr id="14" name="Picture 13" descr="A group of spheres with red and blue spheres&#10;&#10;Description automatically generated">
            <a:extLst>
              <a:ext uri="{FF2B5EF4-FFF2-40B4-BE49-F238E27FC236}">
                <a16:creationId xmlns:a16="http://schemas.microsoft.com/office/drawing/2014/main" id="{5BA5EC18-9808-967E-A2BB-CE66D57F515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18712" y="21488748"/>
            <a:ext cx="9144000" cy="7852775"/>
          </a:xfrm>
          <a:prstGeom prst="rect">
            <a:avLst/>
          </a:prstGeom>
        </p:spPr>
      </p:pic>
      <p:pic>
        <p:nvPicPr>
          <p:cNvPr id="16" name="Picture 15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B172BFB7-5FBD-C944-7BC2-CACD5D4227F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03832" y="21488748"/>
            <a:ext cx="9144000" cy="7852775"/>
          </a:xfrm>
          <a:prstGeom prst="rect">
            <a:avLst/>
          </a:prstGeom>
        </p:spPr>
      </p:pic>
      <p:pic>
        <p:nvPicPr>
          <p:cNvPr id="18" name="Picture 17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FF528153-1B85-F30D-9475-730486F4A93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88952" y="21549708"/>
            <a:ext cx="9144000" cy="7852775"/>
          </a:xfrm>
          <a:prstGeom prst="rect">
            <a:avLst/>
          </a:prstGeom>
        </p:spPr>
      </p:pic>
      <p:pic>
        <p:nvPicPr>
          <p:cNvPr id="20" name="Picture 19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D35F7AF4-7B5B-8DCD-7E80-559CA4061C2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79672" y="32339628"/>
            <a:ext cx="9144000" cy="7852775"/>
          </a:xfrm>
          <a:prstGeom prst="rect">
            <a:avLst/>
          </a:prstGeom>
        </p:spPr>
      </p:pic>
      <p:pic>
        <p:nvPicPr>
          <p:cNvPr id="22" name="Picture 21" descr="A group of white balls with red and blue spheres&#10;&#10;Description automatically generated">
            <a:extLst>
              <a:ext uri="{FF2B5EF4-FFF2-40B4-BE49-F238E27FC236}">
                <a16:creationId xmlns:a16="http://schemas.microsoft.com/office/drawing/2014/main" id="{D10225EB-0E8C-B604-3EAB-C12D16E7B41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64792" y="32278668"/>
            <a:ext cx="9144000" cy="785277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8D33ED8-4C81-F846-5B1B-AE25AA210446}"/>
              </a:ext>
            </a:extLst>
          </p:cNvPr>
          <p:cNvSpPr txBox="1"/>
          <p:nvPr/>
        </p:nvSpPr>
        <p:spPr>
          <a:xfrm>
            <a:off x="5486401" y="905862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3AFD9F0-6C68-529A-777C-C9086EFE80BF}"/>
              </a:ext>
            </a:extLst>
          </p:cNvPr>
          <p:cNvSpPr txBox="1"/>
          <p:nvPr/>
        </p:nvSpPr>
        <p:spPr>
          <a:xfrm>
            <a:off x="16032481" y="905862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i’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1820AF-7617-A78B-80BB-9F5554FEAB26}"/>
              </a:ext>
            </a:extLst>
          </p:cNvPr>
          <p:cNvSpPr txBox="1"/>
          <p:nvPr/>
        </p:nvSpPr>
        <p:spPr>
          <a:xfrm>
            <a:off x="26456641" y="905862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ii’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0A65DB-4D7D-A5CF-FD3F-24E8065965C2}"/>
              </a:ext>
            </a:extLst>
          </p:cNvPr>
          <p:cNvSpPr txBox="1"/>
          <p:nvPr/>
        </p:nvSpPr>
        <p:spPr>
          <a:xfrm>
            <a:off x="37002721" y="911958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v’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0620FCF-1C8A-585D-805E-D40E08130F85}"/>
              </a:ext>
            </a:extLst>
          </p:cNvPr>
          <p:cNvSpPr txBox="1"/>
          <p:nvPr/>
        </p:nvSpPr>
        <p:spPr>
          <a:xfrm>
            <a:off x="5669281" y="1966566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’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283094C-B719-74A3-952A-29DD3B9185D5}"/>
              </a:ext>
            </a:extLst>
          </p:cNvPr>
          <p:cNvSpPr txBox="1"/>
          <p:nvPr/>
        </p:nvSpPr>
        <p:spPr>
          <a:xfrm>
            <a:off x="16093441" y="1966566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i’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544EB03-A3D2-4AB7-9E28-2E204F1EF81D}"/>
              </a:ext>
            </a:extLst>
          </p:cNvPr>
          <p:cNvSpPr txBox="1"/>
          <p:nvPr/>
        </p:nvSpPr>
        <p:spPr>
          <a:xfrm>
            <a:off x="26761441" y="1960470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ii’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9229752-9508-0498-C661-9F0A514D4ABE}"/>
              </a:ext>
            </a:extLst>
          </p:cNvPr>
          <p:cNvSpPr txBox="1"/>
          <p:nvPr/>
        </p:nvSpPr>
        <p:spPr>
          <a:xfrm>
            <a:off x="37124641" y="1972662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viii’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96345F9-2838-CA26-ED20-F9C22B9BF6AC}"/>
              </a:ext>
            </a:extLst>
          </p:cNvPr>
          <p:cNvSpPr txBox="1"/>
          <p:nvPr/>
        </p:nvSpPr>
        <p:spPr>
          <a:xfrm>
            <a:off x="16276321" y="3057750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ix’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44528BF-35AA-642B-E5C2-D11D1625C623}"/>
              </a:ext>
            </a:extLst>
          </p:cNvPr>
          <p:cNvSpPr txBox="1"/>
          <p:nvPr/>
        </p:nvSpPr>
        <p:spPr>
          <a:xfrm>
            <a:off x="26700481" y="30577509"/>
            <a:ext cx="304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x’</a:t>
            </a:r>
          </a:p>
        </p:txBody>
      </p:sp>
    </p:spTree>
    <p:extLst>
      <p:ext uri="{BB962C8B-B14F-4D97-AF65-F5344CB8AC3E}">
        <p14:creationId xmlns:p14="http://schemas.microsoft.com/office/powerpoint/2010/main" val="5486496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8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BBC50ED-081B-96F4-57C4-6866879D2545}"/>
              </a:ext>
            </a:extLst>
          </p:cNvPr>
          <p:cNvSpPr txBox="1"/>
          <p:nvPr/>
        </p:nvSpPr>
        <p:spPr>
          <a:xfrm>
            <a:off x="10546080" y="12289509"/>
            <a:ext cx="2334767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H species on the H</a:t>
            </a:r>
            <a:r>
              <a:rPr lang="en-US" sz="10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0" b="1" dirty="0">
                <a:latin typeface="Arial" panose="020B0604020202020204" pitchFamily="34" charset="0"/>
                <a:cs typeface="Arial" panose="020B0604020202020204" pitchFamily="34" charset="0"/>
              </a:rPr>
              <a:t>O/Pt (111) surface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F5915AC-4973-CA3F-55AC-0C125A172973}"/>
              </a:ext>
            </a:extLst>
          </p:cNvPr>
          <p:cNvGrpSpPr/>
          <p:nvPr/>
        </p:nvGrpSpPr>
        <p:grpSpPr>
          <a:xfrm>
            <a:off x="8264998" y="15392747"/>
            <a:ext cx="27432000" cy="17715863"/>
            <a:chOff x="8264998" y="15392747"/>
            <a:chExt cx="27432000" cy="17715863"/>
          </a:xfrm>
        </p:grpSpPr>
        <p:pic>
          <p:nvPicPr>
            <p:cNvPr id="3" name="Picture 2" descr="A close-up of several spheres&#10;&#10;Description automatically generated">
              <a:extLst>
                <a:ext uri="{FF2B5EF4-FFF2-40B4-BE49-F238E27FC236}">
                  <a16:creationId xmlns:a16="http://schemas.microsoft.com/office/drawing/2014/main" id="{2D37E39F-E8F6-1066-1835-15AD95C432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64998" y="15392747"/>
              <a:ext cx="27432000" cy="1771586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4A37429-6EE5-B0F1-B879-040646A45083}"/>
                </a:ext>
              </a:extLst>
            </p:cNvPr>
            <p:cNvSpPr txBox="1"/>
            <p:nvPr/>
          </p:nvSpPr>
          <p:spPr>
            <a:xfrm>
              <a:off x="10668001" y="24420549"/>
              <a:ext cx="2804160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6EEC770-9353-509C-5B43-A67357F43D64}"/>
                </a:ext>
              </a:extLst>
            </p:cNvPr>
            <p:cNvSpPr txBox="1"/>
            <p:nvPr/>
          </p:nvSpPr>
          <p:spPr>
            <a:xfrm>
              <a:off x="17556480" y="22713669"/>
              <a:ext cx="3230879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0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O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3244E07-F2C3-E186-E23C-09E8421991B0}"/>
                </a:ext>
              </a:extLst>
            </p:cNvPr>
            <p:cNvSpPr txBox="1"/>
            <p:nvPr/>
          </p:nvSpPr>
          <p:spPr>
            <a:xfrm>
              <a:off x="20177760" y="30577509"/>
              <a:ext cx="3230879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0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4980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6938528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11c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654B54D-14BF-E45F-4B65-35A91F82DE50}"/>
              </a:ext>
            </a:extLst>
          </p:cNvPr>
          <p:cNvGrpSpPr>
            <a:grpSpLocks noChangeAspect="1"/>
          </p:cNvGrpSpPr>
          <p:nvPr/>
        </p:nvGrpSpPr>
        <p:grpSpPr>
          <a:xfrm>
            <a:off x="2489633" y="22940772"/>
            <a:ext cx="13511881" cy="13511873"/>
            <a:chOff x="2176876" y="3459624"/>
            <a:chExt cx="1600201" cy="1600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BFF3D36-9814-2160-C2BE-62CB7F86067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6877" y="3459624"/>
              <a:ext cx="1600200" cy="1600200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6943D9F-D71D-2234-827C-EDCD3A6BF657}"/>
                </a:ext>
              </a:extLst>
            </p:cNvPr>
            <p:cNvGrpSpPr/>
            <p:nvPr/>
          </p:nvGrpSpPr>
          <p:grpSpPr>
            <a:xfrm>
              <a:off x="2176876" y="4799160"/>
              <a:ext cx="553357" cy="260664"/>
              <a:chOff x="2176876" y="3132667"/>
              <a:chExt cx="553357" cy="260664"/>
            </a:xfrm>
          </p:grpSpPr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7C150493-966D-A94C-08D0-62788DD701C5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95CFCE83-9956-DE4E-63B7-7961F50DBEEE}"/>
                  </a:ext>
                </a:extLst>
              </p:cNvPr>
              <p:cNvCxnSpPr/>
              <p:nvPr/>
            </p:nvCxnSpPr>
            <p:spPr>
              <a:xfrm>
                <a:off x="2341032" y="3326969"/>
                <a:ext cx="219456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322DB6D-10BB-9576-F791-97FB2DFA64FD}"/>
                  </a:ext>
                </a:extLst>
              </p:cNvPr>
              <p:cNvSpPr txBox="1"/>
              <p:nvPr/>
            </p:nvSpPr>
            <p:spPr>
              <a:xfrm>
                <a:off x="2241847" y="3138686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0E690895-9FD4-8E56-CEE2-4C384C901593}"/>
              </a:ext>
            </a:extLst>
          </p:cNvPr>
          <p:cNvGrpSpPr>
            <a:grpSpLocks noChangeAspect="1"/>
          </p:cNvGrpSpPr>
          <p:nvPr/>
        </p:nvGrpSpPr>
        <p:grpSpPr>
          <a:xfrm>
            <a:off x="29985972" y="9185777"/>
            <a:ext cx="13511873" cy="13511873"/>
            <a:chOff x="5494251" y="3465375"/>
            <a:chExt cx="1600200" cy="1600200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281A4DB-3492-B157-222A-308A53F35A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4251" y="3465375"/>
              <a:ext cx="1600200" cy="1600200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89AC0007-68AF-9A15-15D5-814F344C8F18}"/>
                </a:ext>
              </a:extLst>
            </p:cNvPr>
            <p:cNvGrpSpPr/>
            <p:nvPr/>
          </p:nvGrpSpPr>
          <p:grpSpPr>
            <a:xfrm>
              <a:off x="5494251" y="4802335"/>
              <a:ext cx="553357" cy="260664"/>
              <a:chOff x="2176876" y="3132667"/>
              <a:chExt cx="553357" cy="260664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9B0C0F69-B121-A86B-6973-10000B38EF60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91C9275B-703D-58F8-4032-E0E18CBE2A47}"/>
                  </a:ext>
                </a:extLst>
              </p:cNvPr>
              <p:cNvCxnSpPr/>
              <p:nvPr/>
            </p:nvCxnSpPr>
            <p:spPr>
              <a:xfrm>
                <a:off x="2341032" y="3326969"/>
                <a:ext cx="219456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7D6B864-3054-ECA5-2265-C6E07495101F}"/>
                  </a:ext>
                </a:extLst>
              </p:cNvPr>
              <p:cNvSpPr txBox="1"/>
              <p:nvPr/>
            </p:nvSpPr>
            <p:spPr>
              <a:xfrm>
                <a:off x="2249066" y="3138686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92E5842-975A-16A6-5798-128DC5A0EB4E}"/>
              </a:ext>
            </a:extLst>
          </p:cNvPr>
          <p:cNvGrpSpPr>
            <a:grpSpLocks noChangeAspect="1"/>
          </p:cNvGrpSpPr>
          <p:nvPr/>
        </p:nvGrpSpPr>
        <p:grpSpPr>
          <a:xfrm>
            <a:off x="16194717" y="9137216"/>
            <a:ext cx="13511873" cy="13511873"/>
            <a:chOff x="3835564" y="3459624"/>
            <a:chExt cx="1600200" cy="160020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55FCCFB-0D6E-A7CB-AEB4-E8E40CB4817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35564" y="3459624"/>
              <a:ext cx="1600200" cy="1600200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F02A78F-F39B-6ABB-C9C6-068E32B7BF67}"/>
                </a:ext>
              </a:extLst>
            </p:cNvPr>
            <p:cNvGrpSpPr/>
            <p:nvPr/>
          </p:nvGrpSpPr>
          <p:grpSpPr>
            <a:xfrm>
              <a:off x="3837002" y="4795275"/>
              <a:ext cx="553357" cy="262054"/>
              <a:chOff x="2176876" y="3131277"/>
              <a:chExt cx="553357" cy="262054"/>
            </a:xfrm>
          </p:grpSpPr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C6D0D642-5E1D-37BE-2455-E906195CCB4A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6C4076D3-739F-9FC3-8FB9-FAA42075095B}"/>
                  </a:ext>
                </a:extLst>
              </p:cNvPr>
              <p:cNvCxnSpPr/>
              <p:nvPr/>
            </p:nvCxnSpPr>
            <p:spPr>
              <a:xfrm>
                <a:off x="2326214" y="3326969"/>
                <a:ext cx="256032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7523A3B-0466-BAEA-92F0-18A37764B0E7}"/>
                  </a:ext>
                </a:extLst>
              </p:cNvPr>
              <p:cNvSpPr txBox="1"/>
              <p:nvPr/>
            </p:nvSpPr>
            <p:spPr>
              <a:xfrm>
                <a:off x="2249066" y="3131277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nm</a:t>
                </a:r>
              </a:p>
            </p:txBody>
          </p:sp>
        </p:grp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8DAE33CE-E190-2BE6-8783-9008D16887CC}"/>
              </a:ext>
            </a:extLst>
          </p:cNvPr>
          <p:cNvGrpSpPr>
            <a:grpSpLocks noChangeAspect="1"/>
          </p:cNvGrpSpPr>
          <p:nvPr/>
        </p:nvGrpSpPr>
        <p:grpSpPr>
          <a:xfrm>
            <a:off x="2403463" y="9171143"/>
            <a:ext cx="13523246" cy="13526505"/>
            <a:chOff x="2175530" y="5126118"/>
            <a:chExt cx="1601547" cy="1601933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F7E576D8-1082-1B27-4916-B0C360099F8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6877" y="5126118"/>
              <a:ext cx="1600200" cy="1600200"/>
            </a:xfrm>
            <a:prstGeom prst="rect">
              <a:avLst/>
            </a:prstGeom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99E39DFC-4DA6-AFD3-DACE-779EEF61C116}"/>
                </a:ext>
              </a:extLst>
            </p:cNvPr>
            <p:cNvGrpSpPr/>
            <p:nvPr/>
          </p:nvGrpSpPr>
          <p:grpSpPr>
            <a:xfrm>
              <a:off x="2175530" y="6467387"/>
              <a:ext cx="553357" cy="260664"/>
              <a:chOff x="2176876" y="3132667"/>
              <a:chExt cx="553357" cy="260664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D496363B-80B6-8159-9D95-3968243858EF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0EE2D411-8077-D91F-A5D0-77C22FFE82A2}"/>
                  </a:ext>
                </a:extLst>
              </p:cNvPr>
              <p:cNvCxnSpPr/>
              <p:nvPr/>
            </p:nvCxnSpPr>
            <p:spPr>
              <a:xfrm>
                <a:off x="2326214" y="3326969"/>
                <a:ext cx="256032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90B399E-023A-8B62-0254-A10E4B5B6240}"/>
                  </a:ext>
                </a:extLst>
              </p:cNvPr>
              <p:cNvSpPr txBox="1"/>
              <p:nvPr/>
            </p:nvSpPr>
            <p:spPr>
              <a:xfrm>
                <a:off x="2241847" y="3138496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nm</a:t>
                </a:r>
              </a:p>
            </p:txBody>
          </p:sp>
        </p:grp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6F0F522-0FDC-729B-CC55-0FA7F58AFB22}"/>
              </a:ext>
            </a:extLst>
          </p:cNvPr>
          <p:cNvGrpSpPr>
            <a:grpSpLocks noChangeAspect="1"/>
          </p:cNvGrpSpPr>
          <p:nvPr/>
        </p:nvGrpSpPr>
        <p:grpSpPr>
          <a:xfrm>
            <a:off x="16248336" y="22940772"/>
            <a:ext cx="13511873" cy="13519768"/>
            <a:chOff x="3835564" y="5126118"/>
            <a:chExt cx="1600200" cy="1601135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2FB0E2FA-413E-280A-5EC4-319629A0B31E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35564" y="5126118"/>
              <a:ext cx="1600200" cy="1600200"/>
            </a:xfrm>
            <a:prstGeom prst="rect">
              <a:avLst/>
            </a:prstGeom>
          </p:spPr>
        </p:pic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24259969-7E0B-54D2-A290-BD9C8BAD850F}"/>
                </a:ext>
              </a:extLst>
            </p:cNvPr>
            <p:cNvGrpSpPr/>
            <p:nvPr/>
          </p:nvGrpSpPr>
          <p:grpSpPr>
            <a:xfrm>
              <a:off x="3835564" y="6466589"/>
              <a:ext cx="553357" cy="260664"/>
              <a:chOff x="2176876" y="3132667"/>
              <a:chExt cx="553357" cy="260664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F0F8D4DF-0B20-F4AF-B4F1-F40228C3C847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C169FC7D-1408-2226-0E4B-0FA06D08F928}"/>
                  </a:ext>
                </a:extLst>
              </p:cNvPr>
              <p:cNvCxnSpPr/>
              <p:nvPr/>
            </p:nvCxnSpPr>
            <p:spPr>
              <a:xfrm>
                <a:off x="2341032" y="3326969"/>
                <a:ext cx="219456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28C7F85-EE13-4D1E-DB53-2750AD62F88B}"/>
                  </a:ext>
                </a:extLst>
              </p:cNvPr>
              <p:cNvSpPr txBox="1"/>
              <p:nvPr/>
            </p:nvSpPr>
            <p:spPr>
              <a:xfrm>
                <a:off x="2241847" y="3138686"/>
                <a:ext cx="420236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nm</a:t>
                </a:r>
              </a:p>
            </p:txBody>
          </p:sp>
        </p:grp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E1BD7F3-706F-9F98-36BF-49C7E73F40E2}"/>
              </a:ext>
            </a:extLst>
          </p:cNvPr>
          <p:cNvGrpSpPr>
            <a:grpSpLocks noChangeAspect="1"/>
          </p:cNvGrpSpPr>
          <p:nvPr/>
        </p:nvGrpSpPr>
        <p:grpSpPr>
          <a:xfrm>
            <a:off x="30039590" y="22994391"/>
            <a:ext cx="13511873" cy="13511873"/>
            <a:chOff x="5494251" y="5126118"/>
            <a:chExt cx="1600200" cy="1600200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A462B453-B473-293E-8616-2F09B0267BF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4251" y="5126118"/>
              <a:ext cx="1600200" cy="1600200"/>
            </a:xfrm>
            <a:prstGeom prst="rect">
              <a:avLst/>
            </a:prstGeom>
          </p:spPr>
        </p:pic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E23D9BED-690B-3E75-9F7B-FF178281AE9B}"/>
                </a:ext>
              </a:extLst>
            </p:cNvPr>
            <p:cNvGrpSpPr/>
            <p:nvPr/>
          </p:nvGrpSpPr>
          <p:grpSpPr>
            <a:xfrm>
              <a:off x="5494251" y="6462886"/>
              <a:ext cx="553357" cy="260664"/>
              <a:chOff x="2176876" y="3132667"/>
              <a:chExt cx="553357" cy="260664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2B809A95-75CD-B86D-0D75-DEE8253CE569}"/>
                  </a:ext>
                </a:extLst>
              </p:cNvPr>
              <p:cNvSpPr/>
              <p:nvPr/>
            </p:nvSpPr>
            <p:spPr>
              <a:xfrm>
                <a:off x="2176876" y="3132667"/>
                <a:ext cx="553357" cy="26066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00" dirty="0"/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0A2729AA-3516-4BA0-BD2C-233AA03E2E2C}"/>
                  </a:ext>
                </a:extLst>
              </p:cNvPr>
              <p:cNvCxnSpPr/>
              <p:nvPr/>
            </p:nvCxnSpPr>
            <p:spPr>
              <a:xfrm>
                <a:off x="2339254" y="3324467"/>
                <a:ext cx="228600" cy="0"/>
              </a:xfrm>
              <a:prstGeom prst="line">
                <a:avLst/>
              </a:prstGeom>
              <a:ln w="1270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CF42ED5-FACE-4432-A39B-7789FBB47271}"/>
                  </a:ext>
                </a:extLst>
              </p:cNvPr>
              <p:cNvSpPr txBox="1"/>
              <p:nvPr/>
            </p:nvSpPr>
            <p:spPr>
              <a:xfrm>
                <a:off x="2273598" y="3136379"/>
                <a:ext cx="346251" cy="177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 n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23016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7270607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16a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FDA6C890-776E-0DB6-FEC4-833D97B34D4E}"/>
              </a:ext>
            </a:extLst>
          </p:cNvPr>
          <p:cNvGrpSpPr>
            <a:grpSpLocks noChangeAspect="1"/>
          </p:cNvGrpSpPr>
          <p:nvPr/>
        </p:nvGrpSpPr>
        <p:grpSpPr>
          <a:xfrm>
            <a:off x="177483" y="9563020"/>
            <a:ext cx="45720000" cy="19678530"/>
            <a:chOff x="1959623" y="983892"/>
            <a:chExt cx="8566621" cy="3687194"/>
          </a:xfrm>
        </p:grpSpPr>
        <p:pic>
          <p:nvPicPr>
            <p:cNvPr id="56" name="Picture 55" descr="A close-up of a cloud&#10;&#10;Description automatically generated">
              <a:extLst>
                <a:ext uri="{FF2B5EF4-FFF2-40B4-BE49-F238E27FC236}">
                  <a16:creationId xmlns:a16="http://schemas.microsoft.com/office/drawing/2014/main" id="{02E2121D-2D9C-0A8B-18EB-FA8174B9C3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59623" y="992599"/>
              <a:ext cx="3536717" cy="3657600"/>
            </a:xfrm>
            <a:prstGeom prst="rect">
              <a:avLst/>
            </a:prstGeom>
          </p:spPr>
        </p:pic>
        <p:pic>
          <p:nvPicPr>
            <p:cNvPr id="57" name="Picture 56" descr="A blue and black background&#10;&#10;Description automatically generated">
              <a:extLst>
                <a:ext uri="{FF2B5EF4-FFF2-40B4-BE49-F238E27FC236}">
                  <a16:creationId xmlns:a16="http://schemas.microsoft.com/office/drawing/2014/main" id="{DE4870EF-6045-EDFE-6A12-50E2D04CE88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90320" y="983892"/>
              <a:ext cx="1655023" cy="1828800"/>
            </a:xfrm>
            <a:prstGeom prst="rect">
              <a:avLst/>
            </a:prstGeom>
          </p:spPr>
        </p:pic>
        <p:pic>
          <p:nvPicPr>
            <p:cNvPr id="58" name="Picture 57" descr="A close-up of a person's face&#10;&#10;Description automatically generated">
              <a:extLst>
                <a:ext uri="{FF2B5EF4-FFF2-40B4-BE49-F238E27FC236}">
                  <a16:creationId xmlns:a16="http://schemas.microsoft.com/office/drawing/2014/main" id="{B4C4D6CD-9ED7-8FB8-F8BB-2189548DD9B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15421" y="985625"/>
              <a:ext cx="1655023" cy="1828800"/>
            </a:xfrm>
            <a:prstGeom prst="rect">
              <a:avLst/>
            </a:prstGeom>
          </p:spPr>
        </p:pic>
        <p:pic>
          <p:nvPicPr>
            <p:cNvPr id="59" name="Picture 58" descr="A close-up of a person's face&#10;&#10;Description automatically generated">
              <a:extLst>
                <a:ext uri="{FF2B5EF4-FFF2-40B4-BE49-F238E27FC236}">
                  <a16:creationId xmlns:a16="http://schemas.microsoft.com/office/drawing/2014/main" id="{4A100243-50D1-C1F7-54BF-B9C4ED22493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864025" y="2841955"/>
              <a:ext cx="1655023" cy="1828800"/>
            </a:xfrm>
            <a:prstGeom prst="rect">
              <a:avLst/>
            </a:prstGeom>
          </p:spPr>
        </p:pic>
        <p:pic>
          <p:nvPicPr>
            <p:cNvPr id="60" name="Picture 59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3897C825-0F15-9A16-A6A2-CE8685B576A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88572" y="2842286"/>
              <a:ext cx="1655023" cy="1828800"/>
            </a:xfrm>
            <a:prstGeom prst="rect">
              <a:avLst/>
            </a:prstGeom>
          </p:spPr>
        </p:pic>
        <p:pic>
          <p:nvPicPr>
            <p:cNvPr id="61" name="Picture 60" descr="A close up of red objects&#10;&#10;Description automatically generated">
              <a:extLst>
                <a:ext uri="{FF2B5EF4-FFF2-40B4-BE49-F238E27FC236}">
                  <a16:creationId xmlns:a16="http://schemas.microsoft.com/office/drawing/2014/main" id="{8706FB05-318A-8946-3A4C-571094AC411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510993" y="2833329"/>
              <a:ext cx="1655023" cy="1828800"/>
            </a:xfrm>
            <a:prstGeom prst="rect">
              <a:avLst/>
            </a:prstGeom>
          </p:spPr>
        </p:pic>
        <p:pic>
          <p:nvPicPr>
            <p:cNvPr id="62" name="Picture 61" descr="A purple and black background&#10;&#10;Description automatically generated">
              <a:extLst>
                <a:ext uri="{FF2B5EF4-FFF2-40B4-BE49-F238E27FC236}">
                  <a16:creationId xmlns:a16="http://schemas.microsoft.com/office/drawing/2014/main" id="{0880409D-6EEA-7F5A-5268-74ED77101B4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871221" y="987277"/>
              <a:ext cx="1655023" cy="1828800"/>
            </a:xfrm>
            <a:prstGeom prst="rect">
              <a:avLst/>
            </a:prstGeom>
          </p:spPr>
        </p:pic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60E50834-CA65-26AE-04C4-7E3C24C704BD}"/>
                </a:ext>
              </a:extLst>
            </p:cNvPr>
            <p:cNvSpPr/>
            <p:nvPr/>
          </p:nvSpPr>
          <p:spPr>
            <a:xfrm>
              <a:off x="3812984" y="2812692"/>
              <a:ext cx="474344" cy="440246"/>
            </a:xfrm>
            <a:prstGeom prst="rect">
              <a:avLst/>
            </a:prstGeom>
            <a:noFill/>
            <a:ln w="19050">
              <a:solidFill>
                <a:srgbClr val="FF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20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3D23F85-A010-9FD1-B254-1DC5E9FF4D36}"/>
                </a:ext>
              </a:extLst>
            </p:cNvPr>
            <p:cNvSpPr txBox="1"/>
            <p:nvPr/>
          </p:nvSpPr>
          <p:spPr>
            <a:xfrm>
              <a:off x="6862619" y="2842286"/>
              <a:ext cx="176508" cy="23467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2550802-DE4D-34C6-7AA5-3585BF9C3F8F}"/>
                </a:ext>
              </a:extLst>
            </p:cNvPr>
            <p:cNvSpPr txBox="1"/>
            <p:nvPr/>
          </p:nvSpPr>
          <p:spPr>
            <a:xfrm>
              <a:off x="8513731" y="988194"/>
              <a:ext cx="193306" cy="23467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72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7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65A2C52-599F-A395-1119-D98914E4E3F3}"/>
                </a:ext>
              </a:extLst>
            </p:cNvPr>
            <p:cNvSpPr txBox="1"/>
            <p:nvPr/>
          </p:nvSpPr>
          <p:spPr>
            <a:xfrm>
              <a:off x="8501863" y="2848972"/>
              <a:ext cx="216623" cy="23467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E032EA9-EF97-A17E-2022-1C6B2C04B363}"/>
                </a:ext>
              </a:extLst>
            </p:cNvPr>
            <p:cNvSpPr txBox="1"/>
            <p:nvPr/>
          </p:nvSpPr>
          <p:spPr>
            <a:xfrm>
              <a:off x="10182879" y="992599"/>
              <a:ext cx="206594" cy="23467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28946FD9-CF1A-FAFA-8696-A6A7E9EB759E}"/>
                </a:ext>
              </a:extLst>
            </p:cNvPr>
            <p:cNvSpPr txBox="1"/>
            <p:nvPr/>
          </p:nvSpPr>
          <p:spPr>
            <a:xfrm>
              <a:off x="10177851" y="2849741"/>
              <a:ext cx="216623" cy="23467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356526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7270607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16b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0546977-0513-029C-950E-A33ACC36F7C8}"/>
              </a:ext>
            </a:extLst>
          </p:cNvPr>
          <p:cNvGrpSpPr>
            <a:grpSpLocks noChangeAspect="1"/>
          </p:cNvGrpSpPr>
          <p:nvPr/>
        </p:nvGrpSpPr>
        <p:grpSpPr>
          <a:xfrm>
            <a:off x="121920" y="9870219"/>
            <a:ext cx="45720000" cy="19524922"/>
            <a:chOff x="1703607" y="1457739"/>
            <a:chExt cx="8590060" cy="366842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DF4B704-876B-11B5-2303-E8D9450E386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3607" y="1457739"/>
              <a:ext cx="3536716" cy="36576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2300A52-FE4B-35C6-30FD-6CDB457C36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9588" y="1457739"/>
              <a:ext cx="1655023" cy="18288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1A6EB1E-12CE-1B75-970A-A020C46353A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66821" y="1457739"/>
              <a:ext cx="1655023" cy="18288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9F2CBEA-5122-F694-4C68-19A79B88371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38644" y="1457739"/>
              <a:ext cx="1655023" cy="1828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90C905E-3FE6-E021-A9DC-E71C8086007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9587" y="3297361"/>
              <a:ext cx="1655023" cy="18288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180F3D5-AD7A-9B10-5868-E39D71C851E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66819" y="3297361"/>
              <a:ext cx="1655023" cy="18288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B4A8D53-EE9E-E630-F461-A7975C2AC26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38644" y="3297361"/>
              <a:ext cx="1655023" cy="182880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35569C9-A34A-D90D-D57E-31EF9D3C11DD}"/>
                </a:ext>
              </a:extLst>
            </p:cNvPr>
            <p:cNvSpPr txBox="1"/>
            <p:nvPr/>
          </p:nvSpPr>
          <p:spPr>
            <a:xfrm>
              <a:off x="6638355" y="3311831"/>
              <a:ext cx="169624" cy="225523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E0A067D-4B31-4250-D053-0304E9916A33}"/>
                </a:ext>
              </a:extLst>
            </p:cNvPr>
            <p:cNvSpPr txBox="1"/>
            <p:nvPr/>
          </p:nvSpPr>
          <p:spPr>
            <a:xfrm>
              <a:off x="8294878" y="1457739"/>
              <a:ext cx="185767" cy="225523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72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7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E2A057D-4F93-5CAE-A3C2-985C7AE63734}"/>
                </a:ext>
              </a:extLst>
            </p:cNvPr>
            <p:cNvSpPr txBox="1"/>
            <p:nvPr/>
          </p:nvSpPr>
          <p:spPr>
            <a:xfrm>
              <a:off x="8283010" y="3307095"/>
              <a:ext cx="208175" cy="225523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E1B82C3-11FF-7BB5-688F-F4E545AEF563}"/>
                </a:ext>
              </a:extLst>
            </p:cNvPr>
            <p:cNvSpPr txBox="1"/>
            <p:nvPr/>
          </p:nvSpPr>
          <p:spPr>
            <a:xfrm>
              <a:off x="9953205" y="1462144"/>
              <a:ext cx="198537" cy="225523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0D999AE-9C91-9089-036E-E4A25CAFD213}"/>
                </a:ext>
              </a:extLst>
            </p:cNvPr>
            <p:cNvSpPr txBox="1"/>
            <p:nvPr/>
          </p:nvSpPr>
          <p:spPr>
            <a:xfrm>
              <a:off x="9948177" y="3307864"/>
              <a:ext cx="208175" cy="225523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7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13CD014-656F-6A76-2146-33CE02248A44}"/>
                </a:ext>
              </a:extLst>
            </p:cNvPr>
            <p:cNvSpPr/>
            <p:nvPr/>
          </p:nvSpPr>
          <p:spPr>
            <a:xfrm>
              <a:off x="2474605" y="2138976"/>
              <a:ext cx="1501504" cy="1521884"/>
            </a:xfrm>
            <a:prstGeom prst="rect">
              <a:avLst/>
            </a:prstGeom>
            <a:noFill/>
            <a:ln w="127000">
              <a:solidFill>
                <a:srgbClr val="FF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200"/>
            </a:p>
          </p:txBody>
        </p:sp>
      </p:grpSp>
    </p:spTree>
    <p:extLst>
      <p:ext uri="{BB962C8B-B14F-4D97-AF65-F5344CB8AC3E}">
        <p14:creationId xmlns:p14="http://schemas.microsoft.com/office/powerpoint/2010/main" val="30416289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2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13779B67-5D10-88CB-4EEE-0419F988C8B7}"/>
              </a:ext>
            </a:extLst>
          </p:cNvPr>
          <p:cNvGrpSpPr>
            <a:grpSpLocks noChangeAspect="1"/>
          </p:cNvGrpSpPr>
          <p:nvPr/>
        </p:nvGrpSpPr>
        <p:grpSpPr>
          <a:xfrm>
            <a:off x="2801548" y="13299447"/>
            <a:ext cx="41148000" cy="18402941"/>
            <a:chOff x="3106348" y="1656087"/>
            <a:chExt cx="6054656" cy="2707871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7BD7A50C-94F5-5B49-4B40-C2A74887F1D7}"/>
                </a:ext>
              </a:extLst>
            </p:cNvPr>
            <p:cNvGrpSpPr/>
            <p:nvPr/>
          </p:nvGrpSpPr>
          <p:grpSpPr>
            <a:xfrm>
              <a:off x="3106348" y="1656087"/>
              <a:ext cx="6054656" cy="2707871"/>
              <a:chOff x="3106348" y="1656087"/>
              <a:chExt cx="6054656" cy="2707871"/>
            </a:xfrm>
          </p:grpSpPr>
          <p:pic>
            <p:nvPicPr>
              <p:cNvPr id="20" name="Picture 19" descr="A group of white spheres&#10;&#10;Description automatically generated">
                <a:extLst>
                  <a:ext uri="{FF2B5EF4-FFF2-40B4-BE49-F238E27FC236}">
                    <a16:creationId xmlns:a16="http://schemas.microsoft.com/office/drawing/2014/main" id="{77E2C645-4C2A-305D-2DBF-B2490367C8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06348" y="1985123"/>
                <a:ext cx="2809702" cy="2377440"/>
              </a:xfrm>
              <a:prstGeom prst="rect">
                <a:avLst/>
              </a:prstGeom>
            </p:spPr>
          </p:pic>
          <p:pic>
            <p:nvPicPr>
              <p:cNvPr id="21" name="Picture 20" descr="A group of white balls&#10;&#10;Description automatically generated">
                <a:extLst>
                  <a:ext uri="{FF2B5EF4-FFF2-40B4-BE49-F238E27FC236}">
                    <a16:creationId xmlns:a16="http://schemas.microsoft.com/office/drawing/2014/main" id="{2CD1EADB-B823-602C-F84C-B6B49D9895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42212" y="1986518"/>
                <a:ext cx="3118792" cy="2377440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1EA34CF-9F9F-75A5-B1EB-A319214B4C3C}"/>
                  </a:ext>
                </a:extLst>
              </p:cNvPr>
              <p:cNvSpPr txBox="1"/>
              <p:nvPr/>
            </p:nvSpPr>
            <p:spPr>
              <a:xfrm>
                <a:off x="3179780" y="1656087"/>
                <a:ext cx="2662837" cy="240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0" dirty="0">
                    <a:latin typeface="Arial" panose="020B0604020202020204" pitchFamily="34" charset="0"/>
                    <a:cs typeface="Arial" panose="020B0604020202020204" pitchFamily="34" charset="0"/>
                  </a:rPr>
                  <a:t>Top View</a:t>
                </a:r>
                <a:endParaRPr lang="zh-CN" altLang="en-US" sz="1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76C8465-82CD-FEFC-716D-BD915725F495}"/>
                  </a:ext>
                </a:extLst>
              </p:cNvPr>
              <p:cNvSpPr txBox="1"/>
              <p:nvPr/>
            </p:nvSpPr>
            <p:spPr>
              <a:xfrm>
                <a:off x="6270189" y="1656087"/>
                <a:ext cx="2662837" cy="240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0" dirty="0">
                    <a:latin typeface="Arial" panose="020B0604020202020204" pitchFamily="34" charset="0"/>
                    <a:cs typeface="Arial" panose="020B0604020202020204" pitchFamily="34" charset="0"/>
                  </a:rPr>
                  <a:t>Side View</a:t>
                </a:r>
                <a:endParaRPr lang="zh-CN" altLang="en-US" sz="1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69444B84-9D99-0D73-8CC7-7C9C683E5392}"/>
                </a:ext>
              </a:extLst>
            </p:cNvPr>
            <p:cNvSpPr/>
            <p:nvPr/>
          </p:nvSpPr>
          <p:spPr>
            <a:xfrm>
              <a:off x="3425989" y="2314307"/>
              <a:ext cx="2453204" cy="201994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162385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3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A group of white spheres with red and yellow spheres&#10;&#10;Description automatically generated">
            <a:extLst>
              <a:ext uri="{FF2B5EF4-FFF2-40B4-BE49-F238E27FC236}">
                <a16:creationId xmlns:a16="http://schemas.microsoft.com/office/drawing/2014/main" id="{19DA0562-511F-CD43-8F34-8B5A6F307F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17874" y="11472454"/>
            <a:ext cx="12389158" cy="105733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105D360-E313-1039-D7AA-48686C68275B}"/>
              </a:ext>
            </a:extLst>
          </p:cNvPr>
          <p:cNvSpPr txBox="1"/>
          <p:nvPr/>
        </p:nvSpPr>
        <p:spPr>
          <a:xfrm>
            <a:off x="9392167" y="8913047"/>
            <a:ext cx="9538854" cy="1446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O/Pt (111)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0DDE56-3509-D937-521B-66DAC38A38E8}"/>
              </a:ext>
            </a:extLst>
          </p:cNvPr>
          <p:cNvSpPr txBox="1"/>
          <p:nvPr/>
        </p:nvSpPr>
        <p:spPr>
          <a:xfrm>
            <a:off x="24526102" y="8800089"/>
            <a:ext cx="16006901" cy="1446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O/Pt (111) with (H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O)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C79A5D-091E-3B23-FD6B-1181E43CE002}"/>
              </a:ext>
            </a:extLst>
          </p:cNvPr>
          <p:cNvSpPr txBox="1"/>
          <p:nvPr/>
        </p:nvSpPr>
        <p:spPr>
          <a:xfrm>
            <a:off x="25490352" y="26039525"/>
            <a:ext cx="14081093" cy="1446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O/Pt (111) with (OH)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3A0075D-575D-3776-5563-F91F2BB97C88}"/>
              </a:ext>
            </a:extLst>
          </p:cNvPr>
          <p:cNvSpPr txBox="1"/>
          <p:nvPr/>
        </p:nvSpPr>
        <p:spPr>
          <a:xfrm>
            <a:off x="7737595" y="26053478"/>
            <a:ext cx="13287740" cy="1446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800" b="1" dirty="0">
                <a:latin typeface="Arial" panose="020B0604020202020204" pitchFamily="34" charset="0"/>
                <a:cs typeface="Arial" panose="020B0604020202020204" pitchFamily="34" charset="0"/>
              </a:rPr>
              <a:t>O/Pt (111) with (H)</a:t>
            </a:r>
            <a:r>
              <a:rPr lang="en-US" altLang="zh-CN" sz="8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pic>
        <p:nvPicPr>
          <p:cNvPr id="27" name="Picture 26" descr="A group of white spheres with red and yellow spheres&#10;&#10;Description automatically generated">
            <a:extLst>
              <a:ext uri="{FF2B5EF4-FFF2-40B4-BE49-F238E27FC236}">
                <a16:creationId xmlns:a16="http://schemas.microsoft.com/office/drawing/2014/main" id="{F48498D3-F1DE-16D4-9A84-6A27C145B6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0"/>
          <a:stretch/>
        </p:blipFill>
        <p:spPr>
          <a:xfrm>
            <a:off x="26236844" y="28644077"/>
            <a:ext cx="12389158" cy="10575431"/>
          </a:xfrm>
          <a:prstGeom prst="rect">
            <a:avLst/>
          </a:prstGeom>
          <a:ln>
            <a:noFill/>
          </a:ln>
        </p:spPr>
      </p:pic>
      <p:sp>
        <p:nvSpPr>
          <p:cNvPr id="28" name="Oval 27">
            <a:extLst>
              <a:ext uri="{FF2B5EF4-FFF2-40B4-BE49-F238E27FC236}">
                <a16:creationId xmlns:a16="http://schemas.microsoft.com/office/drawing/2014/main" id="{C0403C4C-AC0E-EDAA-1CF6-533E4B4A9FC1}"/>
              </a:ext>
            </a:extLst>
          </p:cNvPr>
          <p:cNvSpPr/>
          <p:nvPr/>
        </p:nvSpPr>
        <p:spPr>
          <a:xfrm>
            <a:off x="30112715" y="30611652"/>
            <a:ext cx="2158444" cy="2145312"/>
          </a:xfrm>
          <a:prstGeom prst="ellipse">
            <a:avLst/>
          </a:prstGeom>
          <a:noFill/>
          <a:ln w="127000"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800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821CBD26-C3E2-D8F3-2437-35F05E69DB10}"/>
              </a:ext>
            </a:extLst>
          </p:cNvPr>
          <p:cNvGrpSpPr/>
          <p:nvPr/>
        </p:nvGrpSpPr>
        <p:grpSpPr>
          <a:xfrm>
            <a:off x="26214405" y="11411494"/>
            <a:ext cx="12389158" cy="10573314"/>
            <a:chOff x="6934124" y="1336577"/>
            <a:chExt cx="2142309" cy="1828800"/>
          </a:xfrm>
        </p:grpSpPr>
        <p:pic>
          <p:nvPicPr>
            <p:cNvPr id="33" name="Picture 32" descr="A group of white balls with red and yellow spheres&#10;&#10;Description automatically generated">
              <a:extLst>
                <a:ext uri="{FF2B5EF4-FFF2-40B4-BE49-F238E27FC236}">
                  <a16:creationId xmlns:a16="http://schemas.microsoft.com/office/drawing/2014/main" id="{B6E34355-6630-8D5A-F3DB-084DEA2EADC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34124" y="1336577"/>
              <a:ext cx="2142309" cy="1828800"/>
            </a:xfrm>
            <a:prstGeom prst="rect">
              <a:avLst/>
            </a:prstGeom>
          </p:spPr>
        </p:pic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5CF267B1-9B96-D813-CB41-D6FD6E387EB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8201" y="2245448"/>
              <a:ext cx="459877" cy="457200"/>
            </a:xfrm>
            <a:prstGeom prst="ellipse">
              <a:avLst/>
            </a:prstGeom>
            <a:noFill/>
            <a:ln w="127000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00" dirty="0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E38CB640-CB47-2831-2168-60C54BA0D574}"/>
              </a:ext>
            </a:extLst>
          </p:cNvPr>
          <p:cNvGrpSpPr/>
          <p:nvPr/>
        </p:nvGrpSpPr>
        <p:grpSpPr>
          <a:xfrm>
            <a:off x="8156007" y="28644077"/>
            <a:ext cx="12389158" cy="10573314"/>
            <a:chOff x="1490037" y="4823295"/>
            <a:chExt cx="2142309" cy="1828800"/>
          </a:xfrm>
        </p:grpSpPr>
        <p:pic>
          <p:nvPicPr>
            <p:cNvPr id="31" name="Picture 30" descr="A group of white balls with red dots&#10;&#10;Description automatically generated">
              <a:extLst>
                <a:ext uri="{FF2B5EF4-FFF2-40B4-BE49-F238E27FC236}">
                  <a16:creationId xmlns:a16="http://schemas.microsoft.com/office/drawing/2014/main" id="{18771587-8846-9A0F-7CDA-3C8555A78EC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90037" y="4823295"/>
              <a:ext cx="2142309" cy="1828800"/>
            </a:xfrm>
            <a:prstGeom prst="rect">
              <a:avLst/>
            </a:prstGeom>
          </p:spPr>
        </p:pic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2DB6E82B-5806-0175-4862-AAE012D9E83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326190" y="5824598"/>
              <a:ext cx="228600" cy="227269"/>
            </a:xfrm>
            <a:prstGeom prst="ellipse">
              <a:avLst/>
            </a:prstGeom>
            <a:noFill/>
            <a:ln w="127000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00"/>
            </a:p>
          </p:txBody>
        </p:sp>
      </p:grpSp>
    </p:spTree>
    <p:extLst>
      <p:ext uri="{BB962C8B-B14F-4D97-AF65-F5344CB8AC3E}">
        <p14:creationId xmlns:p14="http://schemas.microsoft.com/office/powerpoint/2010/main" val="42907355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4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3C582CE-85A0-07A5-3FAC-905649EA0C23}"/>
              </a:ext>
            </a:extLst>
          </p:cNvPr>
          <p:cNvGrpSpPr>
            <a:grpSpLocks noChangeAspect="1"/>
          </p:cNvGrpSpPr>
          <p:nvPr/>
        </p:nvGrpSpPr>
        <p:grpSpPr>
          <a:xfrm>
            <a:off x="4811898" y="11656871"/>
            <a:ext cx="36576000" cy="18581285"/>
            <a:chOff x="2800218" y="1232711"/>
            <a:chExt cx="6030804" cy="306376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5F26DA1-FEC7-2FCB-3E17-F9C09813EB07}"/>
                </a:ext>
              </a:extLst>
            </p:cNvPr>
            <p:cNvSpPr txBox="1"/>
            <p:nvPr/>
          </p:nvSpPr>
          <p:spPr>
            <a:xfrm>
              <a:off x="2872403" y="1232711"/>
              <a:ext cx="2662837" cy="5226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NO adsorption on Pt (111)</a:t>
              </a:r>
            </a:p>
            <a:p>
              <a:pPr algn="ctr"/>
              <a:r>
                <a:rPr lang="en-US" altLang="zh-CN" sz="10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10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ads</a:t>
              </a:r>
              <a:r>
                <a:rPr lang="en-US" altLang="zh-CN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 = –1.77 eV</a:t>
              </a:r>
              <a:endParaRPr lang="zh-CN" altLang="en-US" sz="10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3" descr="A red and blue ball in a group of white balls&#10;&#10;Description automatically generated">
              <a:extLst>
                <a:ext uri="{FF2B5EF4-FFF2-40B4-BE49-F238E27FC236}">
                  <a16:creationId xmlns:a16="http://schemas.microsoft.com/office/drawing/2014/main" id="{CE303DE4-C57C-2679-2A50-32E55C4ABD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00218" y="1895124"/>
              <a:ext cx="2807208" cy="2401347"/>
            </a:xfrm>
            <a:prstGeom prst="rect">
              <a:avLst/>
            </a:prstGeom>
          </p:spPr>
        </p:pic>
        <p:pic>
          <p:nvPicPr>
            <p:cNvPr id="5" name="Picture 4" descr="A group of white balls&#10;&#10;Description automatically generated">
              <a:extLst>
                <a:ext uri="{FF2B5EF4-FFF2-40B4-BE49-F238E27FC236}">
                  <a16:creationId xmlns:a16="http://schemas.microsoft.com/office/drawing/2014/main" id="{60CA2391-67E4-0DF1-8344-ADADF32B19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23814" y="1895124"/>
              <a:ext cx="2807208" cy="2401346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8C54021-11C8-542D-85E0-839C15599CE0}"/>
                </a:ext>
              </a:extLst>
            </p:cNvPr>
            <p:cNvSpPr txBox="1"/>
            <p:nvPr/>
          </p:nvSpPr>
          <p:spPr>
            <a:xfrm>
              <a:off x="6023814" y="1232711"/>
              <a:ext cx="2662837" cy="5226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sz="10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 adsorption on Pt (111)</a:t>
              </a:r>
            </a:p>
            <a:p>
              <a:pPr algn="ctr"/>
              <a:r>
                <a:rPr lang="en-US" altLang="zh-CN" sz="10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10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ads</a:t>
              </a:r>
              <a:r>
                <a:rPr lang="en-US" altLang="zh-CN" sz="10000" b="1" dirty="0">
                  <a:latin typeface="Arial" panose="020B0604020202020204" pitchFamily="34" charset="0"/>
                  <a:cs typeface="Arial" panose="020B0604020202020204" pitchFamily="34" charset="0"/>
                </a:rPr>
                <a:t> = –0.87 eV</a:t>
              </a:r>
              <a:endParaRPr lang="zh-CN" altLang="en-US" sz="10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292134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5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8CC7DD9-FC56-EC06-8624-4BCAF0B7E098}"/>
              </a:ext>
            </a:extLst>
          </p:cNvPr>
          <p:cNvGrpSpPr>
            <a:grpSpLocks noChangeAspect="1"/>
          </p:cNvGrpSpPr>
          <p:nvPr/>
        </p:nvGrpSpPr>
        <p:grpSpPr>
          <a:xfrm>
            <a:off x="787083" y="14451492"/>
            <a:ext cx="43891200" cy="16302391"/>
            <a:chOff x="4451774" y="3461765"/>
            <a:chExt cx="6356366" cy="2360928"/>
          </a:xfrm>
        </p:grpSpPr>
        <p:pic>
          <p:nvPicPr>
            <p:cNvPr id="3" name="Picture 2" descr="A close-up of a molecule&#10;&#10;Description automatically generated">
              <a:extLst>
                <a:ext uri="{FF2B5EF4-FFF2-40B4-BE49-F238E27FC236}">
                  <a16:creationId xmlns:a16="http://schemas.microsoft.com/office/drawing/2014/main" id="{197C351E-F5CC-AD8E-1647-C354C90C52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69151" y="3778549"/>
              <a:ext cx="1473200" cy="1244600"/>
            </a:xfrm>
            <a:prstGeom prst="rect">
              <a:avLst/>
            </a:prstGeom>
          </p:spPr>
        </p:pic>
        <p:pic>
          <p:nvPicPr>
            <p:cNvPr id="4" name="Picture 3" descr="A group of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C3FE7987-D70F-1049-9537-11EF1808D0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-69" t="-449" r="69" b="40658"/>
            <a:stretch/>
          </p:blipFill>
          <p:spPr>
            <a:xfrm>
              <a:off x="6069151" y="5023149"/>
              <a:ext cx="1472184" cy="799544"/>
            </a:xfrm>
            <a:prstGeom prst="rect">
              <a:avLst/>
            </a:prstGeom>
          </p:spPr>
        </p:pic>
        <p:pic>
          <p:nvPicPr>
            <p:cNvPr id="5" name="Picture 4" descr="A close-up of a molecule&#10;&#10;Description automatically generated">
              <a:extLst>
                <a:ext uri="{FF2B5EF4-FFF2-40B4-BE49-F238E27FC236}">
                  <a16:creationId xmlns:a16="http://schemas.microsoft.com/office/drawing/2014/main" id="{C29ED7AC-DF0C-774A-51A6-AC0E4E1D895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693179" y="3778549"/>
              <a:ext cx="1447800" cy="1244600"/>
            </a:xfrm>
            <a:prstGeom prst="rect">
              <a:avLst/>
            </a:prstGeom>
          </p:spPr>
        </p:pic>
        <p:pic>
          <p:nvPicPr>
            <p:cNvPr id="7" name="Picture 6" descr="A group of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D79B60B0-D7B7-603C-9B6E-82C6D8AF63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40209"/>
            <a:stretch/>
          </p:blipFill>
          <p:spPr>
            <a:xfrm>
              <a:off x="7693179" y="5023149"/>
              <a:ext cx="1472184" cy="799544"/>
            </a:xfrm>
            <a:prstGeom prst="rect">
              <a:avLst/>
            </a:prstGeom>
          </p:spPr>
        </p:pic>
        <p:pic>
          <p:nvPicPr>
            <p:cNvPr id="8" name="Picture 7" descr="A close-up of a molecule&#10;&#10;Description automatically generated">
              <a:extLst>
                <a:ext uri="{FF2B5EF4-FFF2-40B4-BE49-F238E27FC236}">
                  <a16:creationId xmlns:a16="http://schemas.microsoft.com/office/drawing/2014/main" id="{1FB9D5A6-198D-A0D7-649B-24F412147D0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335956" y="3791249"/>
              <a:ext cx="1447800" cy="1231900"/>
            </a:xfrm>
            <a:prstGeom prst="rect">
              <a:avLst/>
            </a:prstGeom>
          </p:spPr>
        </p:pic>
        <p:pic>
          <p:nvPicPr>
            <p:cNvPr id="11" name="Picture 10" descr="A group of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7BF05B68-7B03-5D78-BC80-32438B3C81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40209"/>
            <a:stretch/>
          </p:blipFill>
          <p:spPr>
            <a:xfrm>
              <a:off x="9335956" y="5023149"/>
              <a:ext cx="1472184" cy="799544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99C2122-D17D-D496-0ED8-D85096FEFB45}"/>
                </a:ext>
              </a:extLst>
            </p:cNvPr>
            <p:cNvSpPr txBox="1"/>
            <p:nvPr/>
          </p:nvSpPr>
          <p:spPr>
            <a:xfrm>
              <a:off x="6145351" y="3464659"/>
              <a:ext cx="1263904" cy="209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6 NO/Pt (111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EAB1C4D-5DED-4EDD-4EC8-028BF3494D34}"/>
                </a:ext>
              </a:extLst>
            </p:cNvPr>
            <p:cNvSpPr txBox="1"/>
            <p:nvPr/>
          </p:nvSpPr>
          <p:spPr>
            <a:xfrm>
              <a:off x="9444668" y="3475412"/>
              <a:ext cx="1155192" cy="209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8 NO/Pt (111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003DA85-BAD7-B596-C879-EE859FC313E2}"/>
                </a:ext>
              </a:extLst>
            </p:cNvPr>
            <p:cNvSpPr txBox="1"/>
            <p:nvPr/>
          </p:nvSpPr>
          <p:spPr>
            <a:xfrm>
              <a:off x="7712944" y="3465251"/>
              <a:ext cx="1257347" cy="209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7 NO/Pt (111)</a:t>
              </a:r>
            </a:p>
          </p:txBody>
        </p:sp>
        <p:pic>
          <p:nvPicPr>
            <p:cNvPr id="17" name="Picture 16" descr="A group of white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A9D7F287-81C1-3E8B-ED68-6F596EBD8D5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451774" y="3761611"/>
              <a:ext cx="1472184" cy="1278476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AC0F57C-FA3E-09CD-FDF5-F5A6BA9DEA1A}"/>
                </a:ext>
              </a:extLst>
            </p:cNvPr>
            <p:cNvSpPr txBox="1"/>
            <p:nvPr/>
          </p:nvSpPr>
          <p:spPr>
            <a:xfrm>
              <a:off x="4541182" y="3461765"/>
              <a:ext cx="1251712" cy="209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5 NO/Pt (111)</a:t>
              </a:r>
            </a:p>
          </p:txBody>
        </p:sp>
        <p:pic>
          <p:nvPicPr>
            <p:cNvPr id="19" name="Picture 18" descr="A group of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B9C55641-B1A5-BD22-6BA5-C9255AE6C0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38351"/>
            <a:stretch/>
          </p:blipFill>
          <p:spPr>
            <a:xfrm>
              <a:off x="4451774" y="5021165"/>
              <a:ext cx="1472184" cy="79954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873428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F2FF4A-DCD2-C9D9-E4F4-38D4E2D9C621}"/>
              </a:ext>
            </a:extLst>
          </p:cNvPr>
          <p:cNvSpPr txBox="1"/>
          <p:nvPr/>
        </p:nvSpPr>
        <p:spPr>
          <a:xfrm>
            <a:off x="2704864" y="1564703"/>
            <a:ext cx="25851949" cy="31547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9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9900" dirty="0">
                <a:latin typeface="Arial" panose="020B0604020202020204" pitchFamily="34" charset="0"/>
                <a:cs typeface="Arial" panose="020B0604020202020204" pitchFamily="34" charset="0"/>
              </a:rPr>
              <a:t>ig. 26</a:t>
            </a:r>
            <a:endParaRPr lang="en-US" sz="19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293C314-8E9D-2111-9C46-352523CAF95A}"/>
              </a:ext>
            </a:extLst>
          </p:cNvPr>
          <p:cNvGrpSpPr>
            <a:grpSpLocks noChangeAspect="1"/>
          </p:cNvGrpSpPr>
          <p:nvPr/>
        </p:nvGrpSpPr>
        <p:grpSpPr>
          <a:xfrm>
            <a:off x="1306251" y="14910789"/>
            <a:ext cx="43891200" cy="11459180"/>
            <a:chOff x="4780971" y="3998950"/>
            <a:chExt cx="6419938" cy="1676127"/>
          </a:xfrm>
        </p:grpSpPr>
        <p:pic>
          <p:nvPicPr>
            <p:cNvPr id="10" name="Picture 9" descr="A group of white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878A190C-295A-79EE-10E6-77090DB775D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09292" y="4370685"/>
              <a:ext cx="1528002" cy="1304392"/>
            </a:xfrm>
            <a:prstGeom prst="rect">
              <a:avLst/>
            </a:prstGeom>
          </p:spPr>
        </p:pic>
        <p:pic>
          <p:nvPicPr>
            <p:cNvPr id="12" name="Picture 11" descr="A group of white spheres with red and blue spheres&#10;&#10;Description automatically generated">
              <a:extLst>
                <a:ext uri="{FF2B5EF4-FFF2-40B4-BE49-F238E27FC236}">
                  <a16:creationId xmlns:a16="http://schemas.microsoft.com/office/drawing/2014/main" id="{919BDA6D-7FAE-B883-68C2-261D7A047B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26407" y="4370685"/>
              <a:ext cx="1528002" cy="1304392"/>
            </a:xfrm>
            <a:prstGeom prst="rect">
              <a:avLst/>
            </a:prstGeom>
          </p:spPr>
        </p:pic>
        <p:pic>
          <p:nvPicPr>
            <p:cNvPr id="13" name="Picture 12" descr="A group of spheres with red blue and yellow dots&#10;&#10;Description automatically generated">
              <a:extLst>
                <a:ext uri="{FF2B5EF4-FFF2-40B4-BE49-F238E27FC236}">
                  <a16:creationId xmlns:a16="http://schemas.microsoft.com/office/drawing/2014/main" id="{66F01C46-0F12-1CF3-AFBF-A0DB066EC0F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31389" y="4370685"/>
              <a:ext cx="1528001" cy="1304392"/>
            </a:xfrm>
            <a:prstGeom prst="rect">
              <a:avLst/>
            </a:prstGeom>
          </p:spPr>
        </p:pic>
        <p:pic>
          <p:nvPicPr>
            <p:cNvPr id="20" name="Picture 19" descr="A group of spheres with red and blue dots&#10;&#10;Description automatically generated">
              <a:extLst>
                <a:ext uri="{FF2B5EF4-FFF2-40B4-BE49-F238E27FC236}">
                  <a16:creationId xmlns:a16="http://schemas.microsoft.com/office/drawing/2014/main" id="{CB1DC80D-DE9F-6030-F8C7-2A934DCB6DF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636371" y="4370685"/>
              <a:ext cx="1528002" cy="1304392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27338FC-6DA9-D6FE-E933-AD305CE11CF4}"/>
                </a:ext>
              </a:extLst>
            </p:cNvPr>
            <p:cNvSpPr txBox="1"/>
            <p:nvPr/>
          </p:nvSpPr>
          <p:spPr>
            <a:xfrm>
              <a:off x="4780971" y="3998950"/>
              <a:ext cx="1600879" cy="211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1 NO/H</a:t>
              </a:r>
              <a:r>
                <a:rPr lang="en-US" sz="8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O/Pt (111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8464419-1F92-2607-83FA-DD062825D527}"/>
                </a:ext>
              </a:extLst>
            </p:cNvPr>
            <p:cNvSpPr txBox="1"/>
            <p:nvPr/>
          </p:nvSpPr>
          <p:spPr>
            <a:xfrm>
              <a:off x="6381850" y="3998950"/>
              <a:ext cx="1600879" cy="211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2 NO/H</a:t>
              </a:r>
              <a:r>
                <a:rPr lang="en-US" sz="8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O/Pt (111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DB89FCD-C0E3-30EC-DA09-FEBE9F7DE5BB}"/>
                </a:ext>
              </a:extLst>
            </p:cNvPr>
            <p:cNvSpPr txBox="1"/>
            <p:nvPr/>
          </p:nvSpPr>
          <p:spPr>
            <a:xfrm>
              <a:off x="7999151" y="3998950"/>
              <a:ext cx="1600879" cy="211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3 NO/H</a:t>
              </a:r>
              <a:r>
                <a:rPr lang="en-US" sz="8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O/Pt (111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3FBDACD-10F4-60BD-1B8E-FE5FE427A58D}"/>
                </a:ext>
              </a:extLst>
            </p:cNvPr>
            <p:cNvSpPr txBox="1"/>
            <p:nvPr/>
          </p:nvSpPr>
          <p:spPr>
            <a:xfrm>
              <a:off x="9600030" y="3998950"/>
              <a:ext cx="1600879" cy="211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4 NO/H</a:t>
              </a:r>
              <a:r>
                <a:rPr lang="en-US" sz="8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O/Pt (11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1072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49</TotalTime>
  <Words>243</Words>
  <Application>Microsoft Office PowerPoint</Application>
  <PresentationFormat>Custom</PresentationFormat>
  <Paragraphs>65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 Tan</dc:creator>
  <cp:lastModifiedBy>Shaohua Xie</cp:lastModifiedBy>
  <cp:revision>110</cp:revision>
  <dcterms:created xsi:type="dcterms:W3CDTF">2022-09-18T17:24:10Z</dcterms:created>
  <dcterms:modified xsi:type="dcterms:W3CDTF">2024-08-02T02:01:27Z</dcterms:modified>
</cp:coreProperties>
</file>